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78" y="83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868100" cy="368681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6E9EA-FCC4-442D-9784-2CC21462E19C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A1517-E550-4DB2-AB76-3F79DEDB50FC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6E9EA-FCC4-442D-9784-2CC21462E19C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A1517-E550-4DB2-AB76-3F79DEDB50FC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6E9EA-FCC4-442D-9784-2CC21462E19C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A1517-E550-4DB2-AB76-3F79DEDB50FC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6E9EA-FCC4-442D-9784-2CC21462E19C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A1517-E550-4DB2-AB76-3F79DEDB50FC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6E9EA-FCC4-442D-9784-2CC21462E19C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A1517-E550-4DB2-AB76-3F79DEDB50FC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6E9EA-FCC4-442D-9784-2CC21462E19C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A1517-E550-4DB2-AB76-3F79DEDB50FC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6E9EA-FCC4-442D-9784-2CC21462E19C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A1517-E550-4DB2-AB76-3F79DEDB50FC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6E9EA-FCC4-442D-9784-2CC21462E19C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A1517-E550-4DB2-AB76-3F79DEDB50FC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6E9EA-FCC4-442D-9784-2CC21462E19C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A1517-E550-4DB2-AB76-3F79DEDB50FC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6E9EA-FCC4-442D-9784-2CC21462E19C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A1517-E550-4DB2-AB76-3F79DEDB50FC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6E9EA-FCC4-442D-9784-2CC21462E19C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A1517-E550-4DB2-AB76-3F79DEDB50FC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C6E9EA-FCC4-442D-9784-2CC21462E19C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5A1517-E550-4DB2-AB76-3F79DEDB50FC}" type="slidenum">
              <a:rPr lang="en-NZ" smtClean="0"/>
              <a:pPr/>
              <a:t>‹#›</a:t>
            </a:fld>
            <a:endParaRPr lang="en-NZ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AutoShape 3"/>
          <p:cNvSpPr>
            <a:spLocks noChangeAspect="1" noChangeArrowheads="1" noTextEdit="1"/>
          </p:cNvSpPr>
          <p:nvPr/>
        </p:nvSpPr>
        <p:spPr bwMode="auto">
          <a:xfrm>
            <a:off x="5305425" y="1152524"/>
            <a:ext cx="3171826" cy="2390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NZ"/>
          </a:p>
        </p:txBody>
      </p:sp>
      <p:grpSp>
        <p:nvGrpSpPr>
          <p:cNvPr id="1013" name="Group 1012"/>
          <p:cNvGrpSpPr/>
          <p:nvPr/>
        </p:nvGrpSpPr>
        <p:grpSpPr>
          <a:xfrm>
            <a:off x="4756774" y="1312799"/>
            <a:ext cx="2977526" cy="2265362"/>
            <a:chOff x="5394949" y="1265174"/>
            <a:chExt cx="2977526" cy="2265362"/>
          </a:xfrm>
        </p:grpSpPr>
        <p:sp>
          <p:nvSpPr>
            <p:cNvPr id="53" name="Rectangle 53"/>
            <p:cNvSpPr>
              <a:spLocks noChangeArrowheads="1"/>
            </p:cNvSpPr>
            <p:nvPr/>
          </p:nvSpPr>
          <p:spPr bwMode="auto">
            <a:xfrm>
              <a:off x="7087917" y="3322574"/>
              <a:ext cx="565060" cy="2079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µM ara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2" name="Freeform 191"/>
            <p:cNvSpPr/>
            <p:nvPr/>
          </p:nvSpPr>
          <p:spPr>
            <a:xfrm>
              <a:off x="6513305" y="1427737"/>
              <a:ext cx="1662586" cy="1643974"/>
            </a:xfrm>
            <a:custGeom>
              <a:avLst/>
              <a:gdLst>
                <a:gd name="connsiteX0" fmla="*/ 0 w 1648838"/>
                <a:gd name="connsiteY0" fmla="*/ 0 h 1643974"/>
                <a:gd name="connsiteX1" fmla="*/ 252919 w 1648838"/>
                <a:gd name="connsiteY1" fmla="*/ 4864 h 1643974"/>
                <a:gd name="connsiteX2" fmla="*/ 437745 w 1648838"/>
                <a:gd name="connsiteY2" fmla="*/ 24319 h 1643974"/>
                <a:gd name="connsiteX3" fmla="*/ 554477 w 1648838"/>
                <a:gd name="connsiteY3" fmla="*/ 102140 h 1643974"/>
                <a:gd name="connsiteX4" fmla="*/ 714983 w 1648838"/>
                <a:gd name="connsiteY4" fmla="*/ 510702 h 1643974"/>
                <a:gd name="connsiteX5" fmla="*/ 943583 w 1648838"/>
                <a:gd name="connsiteY5" fmla="*/ 1177047 h 1643974"/>
                <a:gd name="connsiteX6" fmla="*/ 1128409 w 1648838"/>
                <a:gd name="connsiteY6" fmla="*/ 1493195 h 1643974"/>
                <a:gd name="connsiteX7" fmla="*/ 1318098 w 1648838"/>
                <a:gd name="connsiteY7" fmla="*/ 1619655 h 1643974"/>
                <a:gd name="connsiteX8" fmla="*/ 1648838 w 1648838"/>
                <a:gd name="connsiteY8" fmla="*/ 1639110 h 1643974"/>
                <a:gd name="connsiteX9" fmla="*/ 1648838 w 1648838"/>
                <a:gd name="connsiteY9" fmla="*/ 1639110 h 1643974"/>
                <a:gd name="connsiteX10" fmla="*/ 1648838 w 1648838"/>
                <a:gd name="connsiteY10" fmla="*/ 1639110 h 1643974"/>
                <a:gd name="connsiteX0" fmla="*/ 0 w 1648838"/>
                <a:gd name="connsiteY0" fmla="*/ 771 h 1644745"/>
                <a:gd name="connsiteX1" fmla="*/ 252919 w 1648838"/>
                <a:gd name="connsiteY1" fmla="*/ 5635 h 1644745"/>
                <a:gd name="connsiteX2" fmla="*/ 425908 w 1648838"/>
                <a:gd name="connsiteY2" fmla="*/ 16213 h 1644745"/>
                <a:gd name="connsiteX3" fmla="*/ 554477 w 1648838"/>
                <a:gd name="connsiteY3" fmla="*/ 102911 h 1644745"/>
                <a:gd name="connsiteX4" fmla="*/ 714983 w 1648838"/>
                <a:gd name="connsiteY4" fmla="*/ 511473 h 1644745"/>
                <a:gd name="connsiteX5" fmla="*/ 943583 w 1648838"/>
                <a:gd name="connsiteY5" fmla="*/ 1177818 h 1644745"/>
                <a:gd name="connsiteX6" fmla="*/ 1128409 w 1648838"/>
                <a:gd name="connsiteY6" fmla="*/ 1493966 h 1644745"/>
                <a:gd name="connsiteX7" fmla="*/ 1318098 w 1648838"/>
                <a:gd name="connsiteY7" fmla="*/ 1620426 h 1644745"/>
                <a:gd name="connsiteX8" fmla="*/ 1648838 w 1648838"/>
                <a:gd name="connsiteY8" fmla="*/ 1639881 h 1644745"/>
                <a:gd name="connsiteX9" fmla="*/ 1648838 w 1648838"/>
                <a:gd name="connsiteY9" fmla="*/ 1639881 h 1644745"/>
                <a:gd name="connsiteX10" fmla="*/ 1648838 w 1648838"/>
                <a:gd name="connsiteY10" fmla="*/ 1639881 h 1644745"/>
                <a:gd name="connsiteX0" fmla="*/ 0 w 1648838"/>
                <a:gd name="connsiteY0" fmla="*/ 0 h 1643974"/>
                <a:gd name="connsiteX1" fmla="*/ 252919 w 1648838"/>
                <a:gd name="connsiteY1" fmla="*/ 4864 h 1643974"/>
                <a:gd name="connsiteX2" fmla="*/ 425908 w 1648838"/>
                <a:gd name="connsiteY2" fmla="*/ 15442 h 1643974"/>
                <a:gd name="connsiteX3" fmla="*/ 554477 w 1648838"/>
                <a:gd name="connsiteY3" fmla="*/ 102140 h 1643974"/>
                <a:gd name="connsiteX4" fmla="*/ 714983 w 1648838"/>
                <a:gd name="connsiteY4" fmla="*/ 510702 h 1643974"/>
                <a:gd name="connsiteX5" fmla="*/ 943583 w 1648838"/>
                <a:gd name="connsiteY5" fmla="*/ 1177047 h 1643974"/>
                <a:gd name="connsiteX6" fmla="*/ 1128409 w 1648838"/>
                <a:gd name="connsiteY6" fmla="*/ 1493195 h 1643974"/>
                <a:gd name="connsiteX7" fmla="*/ 1318098 w 1648838"/>
                <a:gd name="connsiteY7" fmla="*/ 1619655 h 1643974"/>
                <a:gd name="connsiteX8" fmla="*/ 1648838 w 1648838"/>
                <a:gd name="connsiteY8" fmla="*/ 1639110 h 1643974"/>
                <a:gd name="connsiteX9" fmla="*/ 1648838 w 1648838"/>
                <a:gd name="connsiteY9" fmla="*/ 1639110 h 1643974"/>
                <a:gd name="connsiteX10" fmla="*/ 1648838 w 1648838"/>
                <a:gd name="connsiteY10" fmla="*/ 1639110 h 1643974"/>
                <a:gd name="connsiteX0" fmla="*/ 0 w 1648838"/>
                <a:gd name="connsiteY0" fmla="*/ 0 h 1643974"/>
                <a:gd name="connsiteX1" fmla="*/ 252919 w 1648838"/>
                <a:gd name="connsiteY1" fmla="*/ 4864 h 1643974"/>
                <a:gd name="connsiteX2" fmla="*/ 425908 w 1648838"/>
                <a:gd name="connsiteY2" fmla="*/ 15442 h 1643974"/>
                <a:gd name="connsiteX3" fmla="*/ 578151 w 1648838"/>
                <a:gd name="connsiteY3" fmla="*/ 152447 h 1643974"/>
                <a:gd name="connsiteX4" fmla="*/ 714983 w 1648838"/>
                <a:gd name="connsiteY4" fmla="*/ 510702 h 1643974"/>
                <a:gd name="connsiteX5" fmla="*/ 943583 w 1648838"/>
                <a:gd name="connsiteY5" fmla="*/ 1177047 h 1643974"/>
                <a:gd name="connsiteX6" fmla="*/ 1128409 w 1648838"/>
                <a:gd name="connsiteY6" fmla="*/ 1493195 h 1643974"/>
                <a:gd name="connsiteX7" fmla="*/ 1318098 w 1648838"/>
                <a:gd name="connsiteY7" fmla="*/ 1619655 h 1643974"/>
                <a:gd name="connsiteX8" fmla="*/ 1648838 w 1648838"/>
                <a:gd name="connsiteY8" fmla="*/ 1639110 h 1643974"/>
                <a:gd name="connsiteX9" fmla="*/ 1648838 w 1648838"/>
                <a:gd name="connsiteY9" fmla="*/ 1639110 h 1643974"/>
                <a:gd name="connsiteX10" fmla="*/ 1648838 w 1648838"/>
                <a:gd name="connsiteY10" fmla="*/ 1639110 h 1643974"/>
                <a:gd name="connsiteX0" fmla="*/ 0 w 1648838"/>
                <a:gd name="connsiteY0" fmla="*/ 0 h 1643974"/>
                <a:gd name="connsiteX1" fmla="*/ 252919 w 1648838"/>
                <a:gd name="connsiteY1" fmla="*/ 4864 h 1643974"/>
                <a:gd name="connsiteX2" fmla="*/ 419989 w 1648838"/>
                <a:gd name="connsiteY2" fmla="*/ 24319 h 1643974"/>
                <a:gd name="connsiteX3" fmla="*/ 578151 w 1648838"/>
                <a:gd name="connsiteY3" fmla="*/ 152447 h 1643974"/>
                <a:gd name="connsiteX4" fmla="*/ 714983 w 1648838"/>
                <a:gd name="connsiteY4" fmla="*/ 510702 h 1643974"/>
                <a:gd name="connsiteX5" fmla="*/ 943583 w 1648838"/>
                <a:gd name="connsiteY5" fmla="*/ 1177047 h 1643974"/>
                <a:gd name="connsiteX6" fmla="*/ 1128409 w 1648838"/>
                <a:gd name="connsiteY6" fmla="*/ 1493195 h 1643974"/>
                <a:gd name="connsiteX7" fmla="*/ 1318098 w 1648838"/>
                <a:gd name="connsiteY7" fmla="*/ 1619655 h 1643974"/>
                <a:gd name="connsiteX8" fmla="*/ 1648838 w 1648838"/>
                <a:gd name="connsiteY8" fmla="*/ 1639110 h 1643974"/>
                <a:gd name="connsiteX9" fmla="*/ 1648838 w 1648838"/>
                <a:gd name="connsiteY9" fmla="*/ 1639110 h 1643974"/>
                <a:gd name="connsiteX10" fmla="*/ 1648838 w 1648838"/>
                <a:gd name="connsiteY10" fmla="*/ 1639110 h 1643974"/>
                <a:gd name="connsiteX0" fmla="*/ 0 w 1648838"/>
                <a:gd name="connsiteY0" fmla="*/ 0 h 1643974"/>
                <a:gd name="connsiteX1" fmla="*/ 252919 w 1648838"/>
                <a:gd name="connsiteY1" fmla="*/ 4864 h 1643974"/>
                <a:gd name="connsiteX2" fmla="*/ 419989 w 1648838"/>
                <a:gd name="connsiteY2" fmla="*/ 24319 h 1643974"/>
                <a:gd name="connsiteX3" fmla="*/ 578151 w 1648838"/>
                <a:gd name="connsiteY3" fmla="*/ 152447 h 1643974"/>
                <a:gd name="connsiteX4" fmla="*/ 714983 w 1648838"/>
                <a:gd name="connsiteY4" fmla="*/ 510702 h 1643974"/>
                <a:gd name="connsiteX5" fmla="*/ 943583 w 1648838"/>
                <a:gd name="connsiteY5" fmla="*/ 1177047 h 1643974"/>
                <a:gd name="connsiteX6" fmla="*/ 1128409 w 1648838"/>
                <a:gd name="connsiteY6" fmla="*/ 1493195 h 1643974"/>
                <a:gd name="connsiteX7" fmla="*/ 1318098 w 1648838"/>
                <a:gd name="connsiteY7" fmla="*/ 1619655 h 1643974"/>
                <a:gd name="connsiteX8" fmla="*/ 1648838 w 1648838"/>
                <a:gd name="connsiteY8" fmla="*/ 1639110 h 1643974"/>
                <a:gd name="connsiteX9" fmla="*/ 1648838 w 1648838"/>
                <a:gd name="connsiteY9" fmla="*/ 1639110 h 1643974"/>
                <a:gd name="connsiteX10" fmla="*/ 1648838 w 1648838"/>
                <a:gd name="connsiteY10" fmla="*/ 1639110 h 164397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1648838" h="1643974">
                  <a:moveTo>
                    <a:pt x="0" y="0"/>
                  </a:moveTo>
                  <a:cubicBezTo>
                    <a:pt x="89981" y="405"/>
                    <a:pt x="182921" y="811"/>
                    <a:pt x="252919" y="4864"/>
                  </a:cubicBezTo>
                  <a:cubicBezTo>
                    <a:pt x="322917" y="8917"/>
                    <a:pt x="372689" y="11066"/>
                    <a:pt x="419989" y="24319"/>
                  </a:cubicBezTo>
                  <a:cubicBezTo>
                    <a:pt x="470249" y="40532"/>
                    <a:pt x="528985" y="71383"/>
                    <a:pt x="578151" y="152447"/>
                  </a:cubicBezTo>
                  <a:cubicBezTo>
                    <a:pt x="627317" y="233511"/>
                    <a:pt x="654078" y="339935"/>
                    <a:pt x="714983" y="510702"/>
                  </a:cubicBezTo>
                  <a:cubicBezTo>
                    <a:pt x="775888" y="681469"/>
                    <a:pt x="874679" y="1013298"/>
                    <a:pt x="943583" y="1177047"/>
                  </a:cubicBezTo>
                  <a:cubicBezTo>
                    <a:pt x="1012487" y="1340796"/>
                    <a:pt x="1065990" y="1419427"/>
                    <a:pt x="1128409" y="1493195"/>
                  </a:cubicBezTo>
                  <a:cubicBezTo>
                    <a:pt x="1190828" y="1566963"/>
                    <a:pt x="1231360" y="1595336"/>
                    <a:pt x="1318098" y="1619655"/>
                  </a:cubicBezTo>
                  <a:cubicBezTo>
                    <a:pt x="1404836" y="1643974"/>
                    <a:pt x="1648838" y="1639110"/>
                    <a:pt x="1648838" y="1639110"/>
                  </a:cubicBezTo>
                  <a:lnTo>
                    <a:pt x="1648838" y="1639110"/>
                  </a:lnTo>
                  <a:lnTo>
                    <a:pt x="1648838" y="1639110"/>
                  </a:lnTo>
                </a:path>
              </a:pathLst>
            </a:cu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5" name="Rectangle 5"/>
            <p:cNvSpPr>
              <a:spLocks noChangeArrowheads="1"/>
            </p:cNvSpPr>
            <p:nvPr/>
          </p:nvSpPr>
          <p:spPr bwMode="auto">
            <a:xfrm>
              <a:off x="5407144" y="1265174"/>
              <a:ext cx="2766072" cy="18351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6" name="Oval 6"/>
            <p:cNvSpPr>
              <a:spLocks noChangeArrowheads="1"/>
            </p:cNvSpPr>
            <p:nvPr/>
          </p:nvSpPr>
          <p:spPr bwMode="auto">
            <a:xfrm>
              <a:off x="5914577" y="1385824"/>
              <a:ext cx="92843" cy="93662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7" name="Oval 7"/>
            <p:cNvSpPr>
              <a:spLocks noChangeArrowheads="1"/>
            </p:cNvSpPr>
            <p:nvPr/>
          </p:nvSpPr>
          <p:spPr bwMode="auto">
            <a:xfrm>
              <a:off x="6466831" y="1408049"/>
              <a:ext cx="94444" cy="92075"/>
            </a:xfrm>
            <a:prstGeom prst="ellipse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8" name="Oval 8"/>
            <p:cNvSpPr>
              <a:spLocks noChangeArrowheads="1"/>
            </p:cNvSpPr>
            <p:nvPr/>
          </p:nvSpPr>
          <p:spPr bwMode="auto">
            <a:xfrm>
              <a:off x="6729352" y="1392174"/>
              <a:ext cx="94444" cy="93662"/>
            </a:xfrm>
            <a:prstGeom prst="ellipse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9" name="Oval 9"/>
            <p:cNvSpPr>
              <a:spLocks noChangeArrowheads="1"/>
            </p:cNvSpPr>
            <p:nvPr/>
          </p:nvSpPr>
          <p:spPr bwMode="auto">
            <a:xfrm>
              <a:off x="7020686" y="1487424"/>
              <a:ext cx="92843" cy="92075"/>
            </a:xfrm>
            <a:prstGeom prst="ellipse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0" name="Oval 10"/>
            <p:cNvSpPr>
              <a:spLocks noChangeArrowheads="1"/>
            </p:cNvSpPr>
            <p:nvPr/>
          </p:nvSpPr>
          <p:spPr bwMode="auto">
            <a:xfrm>
              <a:off x="7283207" y="2152587"/>
              <a:ext cx="94444" cy="93662"/>
            </a:xfrm>
            <a:prstGeom prst="ellipse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1" name="Oval 11"/>
            <p:cNvSpPr>
              <a:spLocks noChangeArrowheads="1"/>
            </p:cNvSpPr>
            <p:nvPr/>
          </p:nvSpPr>
          <p:spPr bwMode="auto">
            <a:xfrm>
              <a:off x="7574541" y="2814574"/>
              <a:ext cx="92843" cy="92075"/>
            </a:xfrm>
            <a:prstGeom prst="ellipse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4" name="Oval 14"/>
            <p:cNvSpPr>
              <a:spLocks noChangeArrowheads="1"/>
            </p:cNvSpPr>
            <p:nvPr/>
          </p:nvSpPr>
          <p:spPr bwMode="auto">
            <a:xfrm>
              <a:off x="5914577" y="1385824"/>
              <a:ext cx="92843" cy="93662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5" name="Oval 15"/>
            <p:cNvSpPr>
              <a:spLocks noChangeArrowheads="1"/>
            </p:cNvSpPr>
            <p:nvPr/>
          </p:nvSpPr>
          <p:spPr bwMode="auto">
            <a:xfrm>
              <a:off x="8126794" y="1354074"/>
              <a:ext cx="94444" cy="93662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" name="Line 17"/>
            <p:cNvSpPr>
              <a:spLocks noChangeShapeType="1"/>
            </p:cNvSpPr>
            <p:nvPr/>
          </p:nvSpPr>
          <p:spPr bwMode="auto">
            <a:xfrm>
              <a:off x="5916930" y="3093720"/>
              <a:ext cx="2455545" cy="1905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8" name="Line 18"/>
            <p:cNvSpPr>
              <a:spLocks noChangeShapeType="1"/>
            </p:cNvSpPr>
            <p:nvPr/>
          </p:nvSpPr>
          <p:spPr bwMode="auto">
            <a:xfrm>
              <a:off x="5958408" y="3094806"/>
              <a:ext cx="1601" cy="523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0" name="Line 20"/>
            <p:cNvSpPr>
              <a:spLocks noChangeShapeType="1"/>
            </p:cNvSpPr>
            <p:nvPr/>
          </p:nvSpPr>
          <p:spPr bwMode="auto">
            <a:xfrm>
              <a:off x="5959398" y="3092387"/>
              <a:ext cx="1601" cy="523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1" name="Rectangle 21"/>
            <p:cNvSpPr>
              <a:spLocks noChangeArrowheads="1"/>
            </p:cNvSpPr>
            <p:nvPr/>
          </p:nvSpPr>
          <p:spPr bwMode="auto">
            <a:xfrm>
              <a:off x="5925325" y="3162237"/>
              <a:ext cx="79203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Line 22"/>
            <p:cNvSpPr>
              <a:spLocks noChangeShapeType="1"/>
            </p:cNvSpPr>
            <p:nvPr/>
          </p:nvSpPr>
          <p:spPr bwMode="auto">
            <a:xfrm>
              <a:off x="6513252" y="3092387"/>
              <a:ext cx="1601" cy="523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3" name="Rectangle 23"/>
            <p:cNvSpPr>
              <a:spLocks noChangeArrowheads="1"/>
            </p:cNvSpPr>
            <p:nvPr/>
          </p:nvSpPr>
          <p:spPr bwMode="auto">
            <a:xfrm>
              <a:off x="6341974" y="3162237"/>
              <a:ext cx="342558" cy="195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Line 24"/>
            <p:cNvSpPr>
              <a:spLocks noChangeShapeType="1"/>
            </p:cNvSpPr>
            <p:nvPr/>
          </p:nvSpPr>
          <p:spPr bwMode="auto">
            <a:xfrm>
              <a:off x="7067107" y="3092387"/>
              <a:ext cx="1601" cy="523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5" name="Rectangle 25"/>
            <p:cNvSpPr>
              <a:spLocks noChangeArrowheads="1"/>
            </p:cNvSpPr>
            <p:nvPr/>
          </p:nvSpPr>
          <p:spPr bwMode="auto">
            <a:xfrm>
              <a:off x="6960368" y="3162237"/>
              <a:ext cx="262521" cy="195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Line 26"/>
            <p:cNvSpPr>
              <a:spLocks noChangeShapeType="1"/>
            </p:cNvSpPr>
            <p:nvPr/>
          </p:nvSpPr>
          <p:spPr bwMode="auto">
            <a:xfrm>
              <a:off x="7619362" y="3092387"/>
              <a:ext cx="1601" cy="523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7" name="Rectangle 27"/>
            <p:cNvSpPr>
              <a:spLocks noChangeArrowheads="1"/>
            </p:cNvSpPr>
            <p:nvPr/>
          </p:nvSpPr>
          <p:spPr bwMode="auto">
            <a:xfrm>
              <a:off x="7581659" y="3162237"/>
              <a:ext cx="144066" cy="195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Line 28"/>
            <p:cNvSpPr>
              <a:spLocks noChangeShapeType="1"/>
            </p:cNvSpPr>
            <p:nvPr/>
          </p:nvSpPr>
          <p:spPr bwMode="auto">
            <a:xfrm>
              <a:off x="8173216" y="3092387"/>
              <a:ext cx="1601" cy="523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9" name="Rectangle 29"/>
            <p:cNvSpPr>
              <a:spLocks noChangeArrowheads="1"/>
            </p:cNvSpPr>
            <p:nvPr/>
          </p:nvSpPr>
          <p:spPr bwMode="auto">
            <a:xfrm>
              <a:off x="8100400" y="3162237"/>
              <a:ext cx="224103" cy="195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Line 30"/>
            <p:cNvSpPr>
              <a:spLocks noChangeShapeType="1"/>
            </p:cNvSpPr>
            <p:nvPr/>
          </p:nvSpPr>
          <p:spPr bwMode="auto">
            <a:xfrm flipV="1">
              <a:off x="5958409" y="1265211"/>
              <a:ext cx="1601" cy="1827212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32" name="Rectangle 32"/>
            <p:cNvSpPr>
              <a:spLocks noChangeArrowheads="1"/>
            </p:cNvSpPr>
            <p:nvPr/>
          </p:nvSpPr>
          <p:spPr bwMode="auto">
            <a:xfrm>
              <a:off x="5622254" y="3012256"/>
              <a:ext cx="264122" cy="195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Line 33"/>
            <p:cNvSpPr>
              <a:spLocks noChangeShapeType="1"/>
            </p:cNvSpPr>
            <p:nvPr/>
          </p:nvSpPr>
          <p:spPr bwMode="auto">
            <a:xfrm flipH="1">
              <a:off x="5927995" y="2927324"/>
              <a:ext cx="30414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34" name="Line 34"/>
            <p:cNvSpPr>
              <a:spLocks noChangeShapeType="1"/>
            </p:cNvSpPr>
            <p:nvPr/>
          </p:nvSpPr>
          <p:spPr bwMode="auto">
            <a:xfrm flipH="1">
              <a:off x="5905585" y="2760636"/>
              <a:ext cx="528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35" name="Rectangle 35"/>
            <p:cNvSpPr>
              <a:spLocks noChangeArrowheads="1"/>
            </p:cNvSpPr>
            <p:nvPr/>
          </p:nvSpPr>
          <p:spPr bwMode="auto">
            <a:xfrm>
              <a:off x="5622255" y="2678086"/>
              <a:ext cx="264122" cy="195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Line 36"/>
            <p:cNvSpPr>
              <a:spLocks noChangeShapeType="1"/>
            </p:cNvSpPr>
            <p:nvPr/>
          </p:nvSpPr>
          <p:spPr bwMode="auto">
            <a:xfrm flipH="1">
              <a:off x="5927995" y="2595536"/>
              <a:ext cx="30414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37" name="Line 37"/>
            <p:cNvSpPr>
              <a:spLocks noChangeShapeType="1"/>
            </p:cNvSpPr>
            <p:nvPr/>
          </p:nvSpPr>
          <p:spPr bwMode="auto">
            <a:xfrm flipH="1">
              <a:off x="5905585" y="2428849"/>
              <a:ext cx="528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38" name="Rectangle 38"/>
            <p:cNvSpPr>
              <a:spLocks noChangeArrowheads="1"/>
            </p:cNvSpPr>
            <p:nvPr/>
          </p:nvSpPr>
          <p:spPr bwMode="auto">
            <a:xfrm>
              <a:off x="5622255" y="2346299"/>
              <a:ext cx="264122" cy="195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Line 39"/>
            <p:cNvSpPr>
              <a:spLocks noChangeShapeType="1"/>
            </p:cNvSpPr>
            <p:nvPr/>
          </p:nvSpPr>
          <p:spPr bwMode="auto">
            <a:xfrm flipH="1">
              <a:off x="5927995" y="2262161"/>
              <a:ext cx="30414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40" name="Line 40"/>
            <p:cNvSpPr>
              <a:spLocks noChangeShapeType="1"/>
            </p:cNvSpPr>
            <p:nvPr/>
          </p:nvSpPr>
          <p:spPr bwMode="auto">
            <a:xfrm flipH="1">
              <a:off x="5905585" y="2097061"/>
              <a:ext cx="528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41" name="Rectangle 41"/>
            <p:cNvSpPr>
              <a:spLocks noChangeArrowheads="1"/>
            </p:cNvSpPr>
            <p:nvPr/>
          </p:nvSpPr>
          <p:spPr bwMode="auto">
            <a:xfrm>
              <a:off x="5622255" y="2014511"/>
              <a:ext cx="264122" cy="195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Line 42"/>
            <p:cNvSpPr>
              <a:spLocks noChangeShapeType="1"/>
            </p:cNvSpPr>
            <p:nvPr/>
          </p:nvSpPr>
          <p:spPr bwMode="auto">
            <a:xfrm flipH="1">
              <a:off x="5927995" y="1930374"/>
              <a:ext cx="30414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43" name="Line 43"/>
            <p:cNvSpPr>
              <a:spLocks noChangeShapeType="1"/>
            </p:cNvSpPr>
            <p:nvPr/>
          </p:nvSpPr>
          <p:spPr bwMode="auto">
            <a:xfrm flipH="1">
              <a:off x="5905585" y="1763686"/>
              <a:ext cx="528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44" name="Rectangle 44"/>
            <p:cNvSpPr>
              <a:spLocks noChangeArrowheads="1"/>
            </p:cNvSpPr>
            <p:nvPr/>
          </p:nvSpPr>
          <p:spPr bwMode="auto">
            <a:xfrm>
              <a:off x="5622255" y="1682724"/>
              <a:ext cx="264122" cy="195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Line 45"/>
            <p:cNvSpPr>
              <a:spLocks noChangeShapeType="1"/>
            </p:cNvSpPr>
            <p:nvPr/>
          </p:nvSpPr>
          <p:spPr bwMode="auto">
            <a:xfrm flipH="1">
              <a:off x="5927995" y="1598586"/>
              <a:ext cx="30414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46" name="Line 46"/>
            <p:cNvSpPr>
              <a:spLocks noChangeShapeType="1"/>
            </p:cNvSpPr>
            <p:nvPr/>
          </p:nvSpPr>
          <p:spPr bwMode="auto">
            <a:xfrm flipH="1">
              <a:off x="5905585" y="1431899"/>
              <a:ext cx="528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47" name="Rectangle 47"/>
            <p:cNvSpPr>
              <a:spLocks noChangeArrowheads="1"/>
            </p:cNvSpPr>
            <p:nvPr/>
          </p:nvSpPr>
          <p:spPr bwMode="auto">
            <a:xfrm>
              <a:off x="5622255" y="1349349"/>
              <a:ext cx="264122" cy="195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Line 48"/>
            <p:cNvSpPr>
              <a:spLocks noChangeShapeType="1"/>
            </p:cNvSpPr>
            <p:nvPr/>
          </p:nvSpPr>
          <p:spPr bwMode="auto">
            <a:xfrm flipH="1">
              <a:off x="5927995" y="1266799"/>
              <a:ext cx="30414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54" name="Rectangle 54"/>
            <p:cNvSpPr>
              <a:spLocks noChangeArrowheads="1"/>
            </p:cNvSpPr>
            <p:nvPr/>
          </p:nvSpPr>
          <p:spPr bwMode="auto">
            <a:xfrm rot="16200000">
              <a:off x="4681442" y="2048569"/>
              <a:ext cx="1636712" cy="2096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. act. fr. unsilenced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91" name="Group 190"/>
            <p:cNvGrpSpPr/>
            <p:nvPr/>
          </p:nvGrpSpPr>
          <p:grpSpPr>
            <a:xfrm>
              <a:off x="5998467" y="2546773"/>
              <a:ext cx="1004620" cy="472134"/>
              <a:chOff x="7603503" y="133705"/>
              <a:chExt cx="996313" cy="472134"/>
            </a:xfrm>
          </p:grpSpPr>
          <p:sp>
            <p:nvSpPr>
              <p:cNvPr id="141" name="TextBox 140"/>
              <p:cNvSpPr txBox="1"/>
              <p:nvPr/>
            </p:nvSpPr>
            <p:spPr>
              <a:xfrm>
                <a:off x="7892080" y="159559"/>
                <a:ext cx="394339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GB" sz="1000" b="1" smtClean="0"/>
                  <a:t>pSC101</a:t>
                </a:r>
                <a:endParaRPr lang="en-NZ" sz="1000" b="1"/>
              </a:p>
            </p:txBody>
          </p:sp>
          <p:sp>
            <p:nvSpPr>
              <p:cNvPr id="142" name="TextBox 141"/>
              <p:cNvSpPr txBox="1"/>
              <p:nvPr/>
            </p:nvSpPr>
            <p:spPr>
              <a:xfrm>
                <a:off x="8441888" y="162761"/>
                <a:ext cx="129844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GB" sz="1000" b="1" smtClean="0"/>
                  <a:t>Sp</a:t>
                </a:r>
                <a:endParaRPr lang="en-NZ" sz="1000" b="1"/>
              </a:p>
            </p:txBody>
          </p:sp>
          <p:sp>
            <p:nvSpPr>
              <p:cNvPr id="144" name="Rounded Rectangle 143"/>
              <p:cNvSpPr>
                <a:spLocks noChangeAspect="1"/>
              </p:cNvSpPr>
              <p:nvPr/>
            </p:nvSpPr>
            <p:spPr>
              <a:xfrm>
                <a:off x="7813489" y="168189"/>
                <a:ext cx="786327" cy="340624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Z"/>
              </a:p>
            </p:txBody>
          </p:sp>
          <p:sp>
            <p:nvSpPr>
              <p:cNvPr id="145" name="Bent Arrow 144"/>
              <p:cNvSpPr>
                <a:spLocks noChangeAspect="1"/>
              </p:cNvSpPr>
              <p:nvPr/>
            </p:nvSpPr>
            <p:spPr>
              <a:xfrm>
                <a:off x="7894005" y="327352"/>
                <a:ext cx="98890" cy="181460"/>
              </a:xfrm>
              <a:prstGeom prst="bentArrow">
                <a:avLst/>
              </a:prstGeom>
              <a:solidFill>
                <a:schemeClr val="bg1">
                  <a:lumMod val="8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Z">
                  <a:solidFill>
                    <a:schemeClr val="tx1"/>
                  </a:solidFill>
                </a:endParaRPr>
              </a:p>
            </p:txBody>
          </p:sp>
          <p:sp>
            <p:nvSpPr>
              <p:cNvPr id="146" name="Oval 145"/>
              <p:cNvSpPr/>
              <p:nvPr/>
            </p:nvSpPr>
            <p:spPr>
              <a:xfrm>
                <a:off x="7780744" y="133705"/>
                <a:ext cx="100811" cy="100811"/>
              </a:xfrm>
              <a:prstGeom prst="ellipse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Z"/>
              </a:p>
            </p:txBody>
          </p:sp>
          <p:sp>
            <p:nvSpPr>
              <p:cNvPr id="149" name="TextBox 148"/>
              <p:cNvSpPr txBox="1"/>
              <p:nvPr/>
            </p:nvSpPr>
            <p:spPr>
              <a:xfrm>
                <a:off x="7603503" y="344530"/>
                <a:ext cx="243656" cy="1384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GB" sz="900" b="1" smtClean="0">
                    <a:latin typeface="Arial" pitchFamily="34" charset="0"/>
                    <a:cs typeface="Arial" pitchFamily="34" charset="0"/>
                  </a:rPr>
                  <a:t>p</a:t>
                </a:r>
                <a:r>
                  <a:rPr lang="en-GB" sz="900" b="1" i="1" smtClean="0">
                    <a:latin typeface="Arial" pitchFamily="34" charset="0"/>
                    <a:cs typeface="Arial" pitchFamily="34" charset="0"/>
                  </a:rPr>
                  <a:t>ara</a:t>
                </a:r>
                <a:endParaRPr lang="en-NZ" sz="900" b="1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1" name="Rectangle 150"/>
              <p:cNvSpPr/>
              <p:nvPr/>
            </p:nvSpPr>
            <p:spPr>
              <a:xfrm>
                <a:off x="7939493" y="454622"/>
                <a:ext cx="139638" cy="100811"/>
              </a:xfrm>
              <a:prstGeom prst="rect">
                <a:avLst/>
              </a:prstGeom>
              <a:solidFill>
                <a:schemeClr val="accent6">
                  <a:lumMod val="7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Z"/>
              </a:p>
            </p:txBody>
          </p:sp>
          <p:sp>
            <p:nvSpPr>
              <p:cNvPr id="153" name="Rectangle 152"/>
              <p:cNvSpPr/>
              <p:nvPr/>
            </p:nvSpPr>
            <p:spPr>
              <a:xfrm>
                <a:off x="8077561" y="454622"/>
                <a:ext cx="115213" cy="100811"/>
              </a:xfrm>
              <a:prstGeom prst="rect">
                <a:avLst/>
              </a:prstGeom>
              <a:solidFill>
                <a:schemeClr val="accent6">
                  <a:lumMod val="7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Z"/>
              </a:p>
            </p:txBody>
          </p:sp>
          <p:sp>
            <p:nvSpPr>
              <p:cNvPr id="154" name="Right Arrow 153"/>
              <p:cNvSpPr/>
              <p:nvPr/>
            </p:nvSpPr>
            <p:spPr>
              <a:xfrm>
                <a:off x="8194344" y="404217"/>
                <a:ext cx="144016" cy="201622"/>
              </a:xfrm>
              <a:prstGeom prst="rightArrow">
                <a:avLst/>
              </a:prstGeom>
              <a:solidFill>
                <a:schemeClr val="accent6">
                  <a:lumMod val="7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Z"/>
              </a:p>
            </p:txBody>
          </p:sp>
        </p:grpSp>
        <p:sp>
          <p:nvSpPr>
            <p:cNvPr id="13" name="Oval 13"/>
            <p:cNvSpPr>
              <a:spLocks noChangeArrowheads="1"/>
            </p:cNvSpPr>
            <p:nvPr/>
          </p:nvSpPr>
          <p:spPr bwMode="auto">
            <a:xfrm>
              <a:off x="8126794" y="3016187"/>
              <a:ext cx="94444" cy="93662"/>
            </a:xfrm>
            <a:prstGeom prst="ellipse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2" name="Oval 12"/>
            <p:cNvSpPr>
              <a:spLocks noChangeArrowheads="1"/>
            </p:cNvSpPr>
            <p:nvPr/>
          </p:nvSpPr>
          <p:spPr bwMode="auto">
            <a:xfrm>
              <a:off x="7837062" y="3003487"/>
              <a:ext cx="92843" cy="92075"/>
            </a:xfrm>
            <a:prstGeom prst="ellipse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cxnSp>
          <p:nvCxnSpPr>
            <p:cNvPr id="194" name="Straight Connector 193"/>
            <p:cNvCxnSpPr/>
            <p:nvPr/>
          </p:nvCxnSpPr>
          <p:spPr>
            <a:xfrm flipH="1">
              <a:off x="5970997" y="1433370"/>
              <a:ext cx="506682" cy="3795"/>
            </a:xfrm>
            <a:prstGeom prst="line">
              <a:avLst/>
            </a:prstGeom>
            <a:ln w="1905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Straight Connector 198"/>
            <p:cNvCxnSpPr>
              <a:endCxn id="15" idx="5"/>
            </p:cNvCxnSpPr>
            <p:nvPr/>
          </p:nvCxnSpPr>
          <p:spPr>
            <a:xfrm>
              <a:off x="6967619" y="1431247"/>
              <a:ext cx="1239788" cy="277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21" name="Group 1020"/>
          <p:cNvGrpSpPr/>
          <p:nvPr/>
        </p:nvGrpSpPr>
        <p:grpSpPr>
          <a:xfrm>
            <a:off x="4756774" y="3678237"/>
            <a:ext cx="3408747" cy="2293938"/>
            <a:chOff x="4756774" y="3678237"/>
            <a:chExt cx="3408747" cy="2293938"/>
          </a:xfrm>
        </p:grpSpPr>
        <p:sp>
          <p:nvSpPr>
            <p:cNvPr id="188" name="Freeform 187"/>
            <p:cNvSpPr/>
            <p:nvPr/>
          </p:nvSpPr>
          <p:spPr>
            <a:xfrm>
              <a:off x="5299089" y="3834015"/>
              <a:ext cx="2690834" cy="1545484"/>
            </a:xfrm>
            <a:custGeom>
              <a:avLst/>
              <a:gdLst>
                <a:gd name="connsiteX0" fmla="*/ 0 w 2690834"/>
                <a:gd name="connsiteY0" fmla="*/ 0 h 1542799"/>
                <a:gd name="connsiteX1" fmla="*/ 205438 w 2690834"/>
                <a:gd name="connsiteY1" fmla="*/ 20141 h 1542799"/>
                <a:gd name="connsiteX2" fmla="*/ 414904 w 2690834"/>
                <a:gd name="connsiteY2" fmla="*/ 64451 h 1542799"/>
                <a:gd name="connsiteX3" fmla="*/ 660624 w 2690834"/>
                <a:gd name="connsiteY3" fmla="*/ 245720 h 1542799"/>
                <a:gd name="connsiteX4" fmla="*/ 878147 w 2690834"/>
                <a:gd name="connsiteY4" fmla="*/ 592145 h 1542799"/>
                <a:gd name="connsiteX5" fmla="*/ 1115810 w 2690834"/>
                <a:gd name="connsiteY5" fmla="*/ 930513 h 1542799"/>
                <a:gd name="connsiteX6" fmla="*/ 1341389 w 2690834"/>
                <a:gd name="connsiteY6" fmla="*/ 1240684 h 1542799"/>
                <a:gd name="connsiteX7" fmla="*/ 1595165 w 2690834"/>
                <a:gd name="connsiteY7" fmla="*/ 1430009 h 1542799"/>
                <a:gd name="connsiteX8" fmla="*/ 2255789 w 2690834"/>
                <a:gd name="connsiteY8" fmla="*/ 1522658 h 1542799"/>
                <a:gd name="connsiteX9" fmla="*/ 2690834 w 2690834"/>
                <a:gd name="connsiteY9" fmla="*/ 1542799 h 1542799"/>
                <a:gd name="connsiteX10" fmla="*/ 2690834 w 2690834"/>
                <a:gd name="connsiteY10" fmla="*/ 1542799 h 1542799"/>
                <a:gd name="connsiteX0" fmla="*/ 0 w 2690834"/>
                <a:gd name="connsiteY0" fmla="*/ 0 h 1542799"/>
                <a:gd name="connsiteX1" fmla="*/ 205438 w 2690834"/>
                <a:gd name="connsiteY1" fmla="*/ 20141 h 1542799"/>
                <a:gd name="connsiteX2" fmla="*/ 414904 w 2690834"/>
                <a:gd name="connsiteY2" fmla="*/ 64451 h 1542799"/>
                <a:gd name="connsiteX3" fmla="*/ 660624 w 2690834"/>
                <a:gd name="connsiteY3" fmla="*/ 245720 h 1542799"/>
                <a:gd name="connsiteX4" fmla="*/ 878147 w 2690834"/>
                <a:gd name="connsiteY4" fmla="*/ 592145 h 1542799"/>
                <a:gd name="connsiteX5" fmla="*/ 1115810 w 2690834"/>
                <a:gd name="connsiteY5" fmla="*/ 930513 h 1542799"/>
                <a:gd name="connsiteX6" fmla="*/ 1345417 w 2690834"/>
                <a:gd name="connsiteY6" fmla="*/ 1248741 h 1542799"/>
                <a:gd name="connsiteX7" fmla="*/ 1595165 w 2690834"/>
                <a:gd name="connsiteY7" fmla="*/ 1430009 h 1542799"/>
                <a:gd name="connsiteX8" fmla="*/ 2255789 w 2690834"/>
                <a:gd name="connsiteY8" fmla="*/ 1522658 h 1542799"/>
                <a:gd name="connsiteX9" fmla="*/ 2690834 w 2690834"/>
                <a:gd name="connsiteY9" fmla="*/ 1542799 h 1542799"/>
                <a:gd name="connsiteX10" fmla="*/ 2690834 w 2690834"/>
                <a:gd name="connsiteY10" fmla="*/ 1542799 h 1542799"/>
                <a:gd name="connsiteX0" fmla="*/ 0 w 2690834"/>
                <a:gd name="connsiteY0" fmla="*/ 0 h 1542799"/>
                <a:gd name="connsiteX1" fmla="*/ 205438 w 2690834"/>
                <a:gd name="connsiteY1" fmla="*/ 20141 h 1542799"/>
                <a:gd name="connsiteX2" fmla="*/ 414904 w 2690834"/>
                <a:gd name="connsiteY2" fmla="*/ 64451 h 1542799"/>
                <a:gd name="connsiteX3" fmla="*/ 660624 w 2690834"/>
                <a:gd name="connsiteY3" fmla="*/ 245720 h 1542799"/>
                <a:gd name="connsiteX4" fmla="*/ 878147 w 2690834"/>
                <a:gd name="connsiteY4" fmla="*/ 592145 h 1542799"/>
                <a:gd name="connsiteX5" fmla="*/ 1115810 w 2690834"/>
                <a:gd name="connsiteY5" fmla="*/ 930513 h 1542799"/>
                <a:gd name="connsiteX6" fmla="*/ 1345417 w 2690834"/>
                <a:gd name="connsiteY6" fmla="*/ 1248741 h 1542799"/>
                <a:gd name="connsiteX7" fmla="*/ 1595165 w 2690834"/>
                <a:gd name="connsiteY7" fmla="*/ 1430009 h 1542799"/>
                <a:gd name="connsiteX8" fmla="*/ 2255789 w 2690834"/>
                <a:gd name="connsiteY8" fmla="*/ 1522658 h 1542799"/>
                <a:gd name="connsiteX9" fmla="*/ 2690834 w 2690834"/>
                <a:gd name="connsiteY9" fmla="*/ 1542799 h 1542799"/>
                <a:gd name="connsiteX10" fmla="*/ 2690834 w 2690834"/>
                <a:gd name="connsiteY10" fmla="*/ 1542799 h 1542799"/>
                <a:gd name="connsiteX0" fmla="*/ 0 w 2690834"/>
                <a:gd name="connsiteY0" fmla="*/ 0 h 1542799"/>
                <a:gd name="connsiteX1" fmla="*/ 205438 w 2690834"/>
                <a:gd name="connsiteY1" fmla="*/ 20141 h 1542799"/>
                <a:gd name="connsiteX2" fmla="*/ 414904 w 2690834"/>
                <a:gd name="connsiteY2" fmla="*/ 64451 h 1542799"/>
                <a:gd name="connsiteX3" fmla="*/ 660624 w 2690834"/>
                <a:gd name="connsiteY3" fmla="*/ 245720 h 1542799"/>
                <a:gd name="connsiteX4" fmla="*/ 878147 w 2690834"/>
                <a:gd name="connsiteY4" fmla="*/ 592145 h 1542799"/>
                <a:gd name="connsiteX5" fmla="*/ 1115810 w 2690834"/>
                <a:gd name="connsiteY5" fmla="*/ 930513 h 1542799"/>
                <a:gd name="connsiteX6" fmla="*/ 1345417 w 2690834"/>
                <a:gd name="connsiteY6" fmla="*/ 1248741 h 1542799"/>
                <a:gd name="connsiteX7" fmla="*/ 1595165 w 2690834"/>
                <a:gd name="connsiteY7" fmla="*/ 1430009 h 1542799"/>
                <a:gd name="connsiteX8" fmla="*/ 2255789 w 2690834"/>
                <a:gd name="connsiteY8" fmla="*/ 1522658 h 1542799"/>
                <a:gd name="connsiteX9" fmla="*/ 2690834 w 2690834"/>
                <a:gd name="connsiteY9" fmla="*/ 1542799 h 1542799"/>
                <a:gd name="connsiteX10" fmla="*/ 2690834 w 2690834"/>
                <a:gd name="connsiteY10" fmla="*/ 1542799 h 1542799"/>
                <a:gd name="connsiteX0" fmla="*/ 0 w 2690834"/>
                <a:gd name="connsiteY0" fmla="*/ 0 h 1542799"/>
                <a:gd name="connsiteX1" fmla="*/ 205438 w 2690834"/>
                <a:gd name="connsiteY1" fmla="*/ 20141 h 1542799"/>
                <a:gd name="connsiteX2" fmla="*/ 414904 w 2690834"/>
                <a:gd name="connsiteY2" fmla="*/ 64451 h 1542799"/>
                <a:gd name="connsiteX3" fmla="*/ 660624 w 2690834"/>
                <a:gd name="connsiteY3" fmla="*/ 245720 h 1542799"/>
                <a:gd name="connsiteX4" fmla="*/ 878147 w 2690834"/>
                <a:gd name="connsiteY4" fmla="*/ 592145 h 1542799"/>
                <a:gd name="connsiteX5" fmla="*/ 1115810 w 2690834"/>
                <a:gd name="connsiteY5" fmla="*/ 930513 h 1542799"/>
                <a:gd name="connsiteX6" fmla="*/ 1345417 w 2690834"/>
                <a:gd name="connsiteY6" fmla="*/ 1248741 h 1542799"/>
                <a:gd name="connsiteX7" fmla="*/ 1595165 w 2690834"/>
                <a:gd name="connsiteY7" fmla="*/ 1430009 h 1542799"/>
                <a:gd name="connsiteX8" fmla="*/ 2255789 w 2690834"/>
                <a:gd name="connsiteY8" fmla="*/ 1522658 h 1542799"/>
                <a:gd name="connsiteX9" fmla="*/ 2690834 w 2690834"/>
                <a:gd name="connsiteY9" fmla="*/ 1542799 h 1542799"/>
                <a:gd name="connsiteX10" fmla="*/ 2690834 w 2690834"/>
                <a:gd name="connsiteY10" fmla="*/ 1542799 h 1542799"/>
                <a:gd name="connsiteX0" fmla="*/ 0 w 2690834"/>
                <a:gd name="connsiteY0" fmla="*/ 0 h 1542799"/>
                <a:gd name="connsiteX1" fmla="*/ 205438 w 2690834"/>
                <a:gd name="connsiteY1" fmla="*/ 20141 h 1542799"/>
                <a:gd name="connsiteX2" fmla="*/ 414904 w 2690834"/>
                <a:gd name="connsiteY2" fmla="*/ 64451 h 1542799"/>
                <a:gd name="connsiteX3" fmla="*/ 660624 w 2690834"/>
                <a:gd name="connsiteY3" fmla="*/ 245720 h 1542799"/>
                <a:gd name="connsiteX4" fmla="*/ 894260 w 2690834"/>
                <a:gd name="connsiteY4" fmla="*/ 588117 h 1542799"/>
                <a:gd name="connsiteX5" fmla="*/ 1115810 w 2690834"/>
                <a:gd name="connsiteY5" fmla="*/ 930513 h 1542799"/>
                <a:gd name="connsiteX6" fmla="*/ 1345417 w 2690834"/>
                <a:gd name="connsiteY6" fmla="*/ 1248741 h 1542799"/>
                <a:gd name="connsiteX7" fmla="*/ 1595165 w 2690834"/>
                <a:gd name="connsiteY7" fmla="*/ 1430009 h 1542799"/>
                <a:gd name="connsiteX8" fmla="*/ 2255789 w 2690834"/>
                <a:gd name="connsiteY8" fmla="*/ 1522658 h 1542799"/>
                <a:gd name="connsiteX9" fmla="*/ 2690834 w 2690834"/>
                <a:gd name="connsiteY9" fmla="*/ 1542799 h 1542799"/>
                <a:gd name="connsiteX10" fmla="*/ 2690834 w 2690834"/>
                <a:gd name="connsiteY10" fmla="*/ 1542799 h 1542799"/>
                <a:gd name="connsiteX0" fmla="*/ 0 w 2690834"/>
                <a:gd name="connsiteY0" fmla="*/ 0 h 1542799"/>
                <a:gd name="connsiteX1" fmla="*/ 205438 w 2690834"/>
                <a:gd name="connsiteY1" fmla="*/ 20141 h 1542799"/>
                <a:gd name="connsiteX2" fmla="*/ 414904 w 2690834"/>
                <a:gd name="connsiteY2" fmla="*/ 64451 h 1542799"/>
                <a:gd name="connsiteX3" fmla="*/ 660624 w 2690834"/>
                <a:gd name="connsiteY3" fmla="*/ 245720 h 1542799"/>
                <a:gd name="connsiteX4" fmla="*/ 894260 w 2690834"/>
                <a:gd name="connsiteY4" fmla="*/ 588117 h 1542799"/>
                <a:gd name="connsiteX5" fmla="*/ 1115810 w 2690834"/>
                <a:gd name="connsiteY5" fmla="*/ 930513 h 1542799"/>
                <a:gd name="connsiteX6" fmla="*/ 1276938 w 2690834"/>
                <a:gd name="connsiteY6" fmla="*/ 1148036 h 1542799"/>
                <a:gd name="connsiteX7" fmla="*/ 1595165 w 2690834"/>
                <a:gd name="connsiteY7" fmla="*/ 1430009 h 1542799"/>
                <a:gd name="connsiteX8" fmla="*/ 2255789 w 2690834"/>
                <a:gd name="connsiteY8" fmla="*/ 1522658 h 1542799"/>
                <a:gd name="connsiteX9" fmla="*/ 2690834 w 2690834"/>
                <a:gd name="connsiteY9" fmla="*/ 1542799 h 1542799"/>
                <a:gd name="connsiteX10" fmla="*/ 2690834 w 2690834"/>
                <a:gd name="connsiteY10" fmla="*/ 1542799 h 1542799"/>
                <a:gd name="connsiteX0" fmla="*/ 0 w 2690834"/>
                <a:gd name="connsiteY0" fmla="*/ 2685 h 1545484"/>
                <a:gd name="connsiteX1" fmla="*/ 205438 w 2690834"/>
                <a:gd name="connsiteY1" fmla="*/ 10742 h 1545484"/>
                <a:gd name="connsiteX2" fmla="*/ 414904 w 2690834"/>
                <a:gd name="connsiteY2" fmla="*/ 67136 h 1545484"/>
                <a:gd name="connsiteX3" fmla="*/ 660624 w 2690834"/>
                <a:gd name="connsiteY3" fmla="*/ 248405 h 1545484"/>
                <a:gd name="connsiteX4" fmla="*/ 894260 w 2690834"/>
                <a:gd name="connsiteY4" fmla="*/ 590802 h 1545484"/>
                <a:gd name="connsiteX5" fmla="*/ 1115810 w 2690834"/>
                <a:gd name="connsiteY5" fmla="*/ 933198 h 1545484"/>
                <a:gd name="connsiteX6" fmla="*/ 1276938 w 2690834"/>
                <a:gd name="connsiteY6" fmla="*/ 1150721 h 1545484"/>
                <a:gd name="connsiteX7" fmla="*/ 1595165 w 2690834"/>
                <a:gd name="connsiteY7" fmla="*/ 1432694 h 1545484"/>
                <a:gd name="connsiteX8" fmla="*/ 2255789 w 2690834"/>
                <a:gd name="connsiteY8" fmla="*/ 1525343 h 1545484"/>
                <a:gd name="connsiteX9" fmla="*/ 2690834 w 2690834"/>
                <a:gd name="connsiteY9" fmla="*/ 1545484 h 1545484"/>
                <a:gd name="connsiteX10" fmla="*/ 2690834 w 2690834"/>
                <a:gd name="connsiteY10" fmla="*/ 1545484 h 1545484"/>
                <a:gd name="connsiteX0" fmla="*/ 0 w 2690834"/>
                <a:gd name="connsiteY0" fmla="*/ 2685 h 1545484"/>
                <a:gd name="connsiteX1" fmla="*/ 205438 w 2690834"/>
                <a:gd name="connsiteY1" fmla="*/ 10742 h 1545484"/>
                <a:gd name="connsiteX2" fmla="*/ 414904 w 2690834"/>
                <a:gd name="connsiteY2" fmla="*/ 67136 h 1545484"/>
                <a:gd name="connsiteX3" fmla="*/ 660624 w 2690834"/>
                <a:gd name="connsiteY3" fmla="*/ 248405 h 1545484"/>
                <a:gd name="connsiteX4" fmla="*/ 894260 w 2690834"/>
                <a:gd name="connsiteY4" fmla="*/ 590802 h 1545484"/>
                <a:gd name="connsiteX5" fmla="*/ 1115810 w 2690834"/>
                <a:gd name="connsiteY5" fmla="*/ 933198 h 1545484"/>
                <a:gd name="connsiteX6" fmla="*/ 1276938 w 2690834"/>
                <a:gd name="connsiteY6" fmla="*/ 1150721 h 1545484"/>
                <a:gd name="connsiteX7" fmla="*/ 1660479 w 2690834"/>
                <a:gd name="connsiteY7" fmla="*/ 1442742 h 1545484"/>
                <a:gd name="connsiteX8" fmla="*/ 2255789 w 2690834"/>
                <a:gd name="connsiteY8" fmla="*/ 1525343 h 1545484"/>
                <a:gd name="connsiteX9" fmla="*/ 2690834 w 2690834"/>
                <a:gd name="connsiteY9" fmla="*/ 1545484 h 1545484"/>
                <a:gd name="connsiteX10" fmla="*/ 2690834 w 2690834"/>
                <a:gd name="connsiteY10" fmla="*/ 1545484 h 154548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2690834" h="1545484">
                  <a:moveTo>
                    <a:pt x="0" y="2685"/>
                  </a:moveTo>
                  <a:cubicBezTo>
                    <a:pt x="68143" y="7384"/>
                    <a:pt x="136287" y="0"/>
                    <a:pt x="205438" y="10742"/>
                  </a:cubicBezTo>
                  <a:cubicBezTo>
                    <a:pt x="274589" y="21484"/>
                    <a:pt x="339040" y="27526"/>
                    <a:pt x="414904" y="67136"/>
                  </a:cubicBezTo>
                  <a:cubicBezTo>
                    <a:pt x="490768" y="106747"/>
                    <a:pt x="580731" y="161127"/>
                    <a:pt x="660624" y="248405"/>
                  </a:cubicBezTo>
                  <a:cubicBezTo>
                    <a:pt x="740517" y="335683"/>
                    <a:pt x="826453" y="468613"/>
                    <a:pt x="894260" y="590802"/>
                  </a:cubicBezTo>
                  <a:cubicBezTo>
                    <a:pt x="970124" y="704934"/>
                    <a:pt x="1052030" y="839878"/>
                    <a:pt x="1115810" y="933198"/>
                  </a:cubicBezTo>
                  <a:cubicBezTo>
                    <a:pt x="1179590" y="1026518"/>
                    <a:pt x="1197046" y="1067472"/>
                    <a:pt x="1276938" y="1150721"/>
                  </a:cubicBezTo>
                  <a:cubicBezTo>
                    <a:pt x="1360859" y="1250083"/>
                    <a:pt x="1497337" y="1380305"/>
                    <a:pt x="1660479" y="1442742"/>
                  </a:cubicBezTo>
                  <a:cubicBezTo>
                    <a:pt x="1823621" y="1505179"/>
                    <a:pt x="2084063" y="1508219"/>
                    <a:pt x="2255789" y="1525343"/>
                  </a:cubicBezTo>
                  <a:cubicBezTo>
                    <a:pt x="2427515" y="1542467"/>
                    <a:pt x="2690834" y="1545484"/>
                    <a:pt x="2690834" y="1545484"/>
                  </a:cubicBezTo>
                  <a:lnTo>
                    <a:pt x="2690834" y="1545484"/>
                  </a:lnTo>
                </a:path>
              </a:pathLst>
            </a:cu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57" name="Rectangle 58"/>
            <p:cNvSpPr>
              <a:spLocks noChangeArrowheads="1"/>
            </p:cNvSpPr>
            <p:nvPr/>
          </p:nvSpPr>
          <p:spPr bwMode="auto">
            <a:xfrm>
              <a:off x="5298111" y="3678237"/>
              <a:ext cx="2743200" cy="18351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74" name="Line 75"/>
            <p:cNvSpPr>
              <a:spLocks noChangeShapeType="1"/>
            </p:cNvSpPr>
            <p:nvPr/>
          </p:nvSpPr>
          <p:spPr bwMode="auto">
            <a:xfrm>
              <a:off x="5298111" y="5505449"/>
              <a:ext cx="2743200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75" name="Line 76"/>
            <p:cNvSpPr>
              <a:spLocks noChangeShapeType="1"/>
            </p:cNvSpPr>
            <p:nvPr/>
          </p:nvSpPr>
          <p:spPr bwMode="auto">
            <a:xfrm>
              <a:off x="5298111" y="5505449"/>
              <a:ext cx="1587" cy="523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76" name="Rectangle 77"/>
            <p:cNvSpPr>
              <a:spLocks noChangeArrowheads="1"/>
            </p:cNvSpPr>
            <p:nvPr/>
          </p:nvSpPr>
          <p:spPr bwMode="auto">
            <a:xfrm>
              <a:off x="5262626" y="5582026"/>
              <a:ext cx="117020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 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Line 78"/>
            <p:cNvSpPr>
              <a:spLocks noChangeShapeType="1"/>
            </p:cNvSpPr>
            <p:nvPr/>
          </p:nvSpPr>
          <p:spPr bwMode="auto">
            <a:xfrm>
              <a:off x="5845798" y="5505449"/>
              <a:ext cx="1587" cy="523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78" name="Rectangle 79"/>
            <p:cNvSpPr>
              <a:spLocks noChangeArrowheads="1"/>
            </p:cNvSpPr>
            <p:nvPr/>
          </p:nvSpPr>
          <p:spPr bwMode="auto">
            <a:xfrm>
              <a:off x="7929879" y="5582026"/>
              <a:ext cx="23564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" name="Line 80"/>
            <p:cNvSpPr>
              <a:spLocks noChangeShapeType="1"/>
            </p:cNvSpPr>
            <p:nvPr/>
          </p:nvSpPr>
          <p:spPr bwMode="auto">
            <a:xfrm>
              <a:off x="6395073" y="5505449"/>
              <a:ext cx="1587" cy="523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80" name="Rectangle 81"/>
            <p:cNvSpPr>
              <a:spLocks noChangeArrowheads="1"/>
            </p:cNvSpPr>
            <p:nvPr/>
          </p:nvSpPr>
          <p:spPr bwMode="auto">
            <a:xfrm>
              <a:off x="5697518" y="5582026"/>
              <a:ext cx="339725" cy="1952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" name="Line 82"/>
            <p:cNvSpPr>
              <a:spLocks noChangeShapeType="1"/>
            </p:cNvSpPr>
            <p:nvPr/>
          </p:nvSpPr>
          <p:spPr bwMode="auto">
            <a:xfrm>
              <a:off x="6944348" y="5505449"/>
              <a:ext cx="1587" cy="523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82" name="Rectangle 83"/>
            <p:cNvSpPr>
              <a:spLocks noChangeArrowheads="1"/>
            </p:cNvSpPr>
            <p:nvPr/>
          </p:nvSpPr>
          <p:spPr bwMode="auto">
            <a:xfrm>
              <a:off x="6286480" y="5582026"/>
              <a:ext cx="260350" cy="1952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" name="Line 84"/>
            <p:cNvSpPr>
              <a:spLocks noChangeShapeType="1"/>
            </p:cNvSpPr>
            <p:nvPr/>
          </p:nvSpPr>
          <p:spPr bwMode="auto">
            <a:xfrm>
              <a:off x="7492036" y="5505449"/>
              <a:ext cx="1587" cy="523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84" name="Rectangle 85"/>
            <p:cNvSpPr>
              <a:spLocks noChangeArrowheads="1"/>
            </p:cNvSpPr>
            <p:nvPr/>
          </p:nvSpPr>
          <p:spPr bwMode="auto">
            <a:xfrm>
              <a:off x="6909018" y="5582026"/>
              <a:ext cx="142875" cy="1952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" name="Line 86"/>
            <p:cNvSpPr>
              <a:spLocks noChangeShapeType="1"/>
            </p:cNvSpPr>
            <p:nvPr/>
          </p:nvSpPr>
          <p:spPr bwMode="auto">
            <a:xfrm>
              <a:off x="8041311" y="5505449"/>
              <a:ext cx="1587" cy="523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86" name="Rectangle 87"/>
            <p:cNvSpPr>
              <a:spLocks noChangeArrowheads="1"/>
            </p:cNvSpPr>
            <p:nvPr/>
          </p:nvSpPr>
          <p:spPr bwMode="auto">
            <a:xfrm>
              <a:off x="7410549" y="5582026"/>
              <a:ext cx="222250" cy="1952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Line 88"/>
            <p:cNvSpPr>
              <a:spLocks noChangeShapeType="1"/>
            </p:cNvSpPr>
            <p:nvPr/>
          </p:nvSpPr>
          <p:spPr bwMode="auto">
            <a:xfrm flipV="1">
              <a:off x="5298111" y="3678237"/>
              <a:ext cx="1587" cy="1827213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88" name="Line 89"/>
            <p:cNvSpPr>
              <a:spLocks noChangeShapeType="1"/>
            </p:cNvSpPr>
            <p:nvPr/>
          </p:nvSpPr>
          <p:spPr bwMode="auto">
            <a:xfrm flipH="1">
              <a:off x="5245723" y="5505449"/>
              <a:ext cx="52387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89" name="Rectangle 90"/>
            <p:cNvSpPr>
              <a:spLocks noChangeArrowheads="1"/>
            </p:cNvSpPr>
            <p:nvPr/>
          </p:nvSpPr>
          <p:spPr bwMode="auto">
            <a:xfrm>
              <a:off x="4964736" y="5422899"/>
              <a:ext cx="261937" cy="1952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" name="Line 91"/>
            <p:cNvSpPr>
              <a:spLocks noChangeShapeType="1"/>
            </p:cNvSpPr>
            <p:nvPr/>
          </p:nvSpPr>
          <p:spPr bwMode="auto">
            <a:xfrm flipH="1">
              <a:off x="5267948" y="5340349"/>
              <a:ext cx="30162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91" name="Line 92"/>
            <p:cNvSpPr>
              <a:spLocks noChangeShapeType="1"/>
            </p:cNvSpPr>
            <p:nvPr/>
          </p:nvSpPr>
          <p:spPr bwMode="auto">
            <a:xfrm flipH="1">
              <a:off x="5245723" y="5173662"/>
              <a:ext cx="52387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92" name="Rectangle 93"/>
            <p:cNvSpPr>
              <a:spLocks noChangeArrowheads="1"/>
            </p:cNvSpPr>
            <p:nvPr/>
          </p:nvSpPr>
          <p:spPr bwMode="auto">
            <a:xfrm>
              <a:off x="4964736" y="5091112"/>
              <a:ext cx="261937" cy="1952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" name="Line 94"/>
            <p:cNvSpPr>
              <a:spLocks noChangeShapeType="1"/>
            </p:cNvSpPr>
            <p:nvPr/>
          </p:nvSpPr>
          <p:spPr bwMode="auto">
            <a:xfrm flipH="1">
              <a:off x="5267948" y="5008562"/>
              <a:ext cx="30162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94" name="Line 95"/>
            <p:cNvSpPr>
              <a:spLocks noChangeShapeType="1"/>
            </p:cNvSpPr>
            <p:nvPr/>
          </p:nvSpPr>
          <p:spPr bwMode="auto">
            <a:xfrm flipH="1">
              <a:off x="5245723" y="4841874"/>
              <a:ext cx="52387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95" name="Rectangle 96"/>
            <p:cNvSpPr>
              <a:spLocks noChangeArrowheads="1"/>
            </p:cNvSpPr>
            <p:nvPr/>
          </p:nvSpPr>
          <p:spPr bwMode="auto">
            <a:xfrm>
              <a:off x="4964736" y="4759324"/>
              <a:ext cx="261937" cy="1952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" name="Line 97"/>
            <p:cNvSpPr>
              <a:spLocks noChangeShapeType="1"/>
            </p:cNvSpPr>
            <p:nvPr/>
          </p:nvSpPr>
          <p:spPr bwMode="auto">
            <a:xfrm flipH="1">
              <a:off x="5267948" y="4675187"/>
              <a:ext cx="30162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97" name="Line 98"/>
            <p:cNvSpPr>
              <a:spLocks noChangeShapeType="1"/>
            </p:cNvSpPr>
            <p:nvPr/>
          </p:nvSpPr>
          <p:spPr bwMode="auto">
            <a:xfrm flipH="1">
              <a:off x="5245723" y="4510087"/>
              <a:ext cx="52387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98" name="Rectangle 99"/>
            <p:cNvSpPr>
              <a:spLocks noChangeArrowheads="1"/>
            </p:cNvSpPr>
            <p:nvPr/>
          </p:nvSpPr>
          <p:spPr bwMode="auto">
            <a:xfrm>
              <a:off x="4964736" y="4427537"/>
              <a:ext cx="261937" cy="1952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" name="Line 100"/>
            <p:cNvSpPr>
              <a:spLocks noChangeShapeType="1"/>
            </p:cNvSpPr>
            <p:nvPr/>
          </p:nvSpPr>
          <p:spPr bwMode="auto">
            <a:xfrm flipH="1">
              <a:off x="5267948" y="4343399"/>
              <a:ext cx="30162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00" name="Line 101"/>
            <p:cNvSpPr>
              <a:spLocks noChangeShapeType="1"/>
            </p:cNvSpPr>
            <p:nvPr/>
          </p:nvSpPr>
          <p:spPr bwMode="auto">
            <a:xfrm flipH="1">
              <a:off x="5245723" y="4176712"/>
              <a:ext cx="52387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01" name="Rectangle 102"/>
            <p:cNvSpPr>
              <a:spLocks noChangeArrowheads="1"/>
            </p:cNvSpPr>
            <p:nvPr/>
          </p:nvSpPr>
          <p:spPr bwMode="auto">
            <a:xfrm>
              <a:off x="4964736" y="4095749"/>
              <a:ext cx="261937" cy="1952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" name="Line 103"/>
            <p:cNvSpPr>
              <a:spLocks noChangeShapeType="1"/>
            </p:cNvSpPr>
            <p:nvPr/>
          </p:nvSpPr>
          <p:spPr bwMode="auto">
            <a:xfrm flipH="1">
              <a:off x="5267948" y="4011612"/>
              <a:ext cx="30162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03" name="Line 104"/>
            <p:cNvSpPr>
              <a:spLocks noChangeShapeType="1"/>
            </p:cNvSpPr>
            <p:nvPr/>
          </p:nvSpPr>
          <p:spPr bwMode="auto">
            <a:xfrm flipH="1">
              <a:off x="5245723" y="3844924"/>
              <a:ext cx="52387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04" name="Rectangle 105"/>
            <p:cNvSpPr>
              <a:spLocks noChangeArrowheads="1"/>
            </p:cNvSpPr>
            <p:nvPr/>
          </p:nvSpPr>
          <p:spPr bwMode="auto">
            <a:xfrm>
              <a:off x="4964736" y="3762374"/>
              <a:ext cx="261937" cy="1952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" name="Rectangle 113"/>
            <p:cNvSpPr>
              <a:spLocks noChangeArrowheads="1"/>
            </p:cNvSpPr>
            <p:nvPr/>
          </p:nvSpPr>
          <p:spPr bwMode="auto">
            <a:xfrm>
              <a:off x="6412536" y="5764212"/>
              <a:ext cx="598487" cy="2079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M aTc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" name="Rectangle 114"/>
            <p:cNvSpPr>
              <a:spLocks noChangeArrowheads="1"/>
            </p:cNvSpPr>
            <p:nvPr/>
          </p:nvSpPr>
          <p:spPr bwMode="auto">
            <a:xfrm rot="16200000">
              <a:off x="4042398" y="4464049"/>
              <a:ext cx="1636713" cy="2079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. act. fr. unsilenced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00" name="Group 199"/>
            <p:cNvGrpSpPr/>
            <p:nvPr/>
          </p:nvGrpSpPr>
          <p:grpSpPr>
            <a:xfrm>
              <a:off x="5348003" y="4956954"/>
              <a:ext cx="994237" cy="485803"/>
              <a:chOff x="3936918" y="211854"/>
              <a:chExt cx="994237" cy="485803"/>
            </a:xfrm>
          </p:grpSpPr>
          <p:sp>
            <p:nvSpPr>
              <p:cNvPr id="159" name="TextBox 158"/>
              <p:cNvSpPr txBox="1"/>
              <p:nvPr/>
            </p:nvSpPr>
            <p:spPr>
              <a:xfrm>
                <a:off x="4221249" y="243739"/>
                <a:ext cx="203582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GB" sz="1000" b="1" smtClean="0"/>
                  <a:t>pP1</a:t>
                </a:r>
                <a:endParaRPr lang="en-NZ" sz="1000" b="1"/>
              </a:p>
            </p:txBody>
          </p:sp>
          <p:sp>
            <p:nvSpPr>
              <p:cNvPr id="160" name="TextBox 159"/>
              <p:cNvSpPr txBox="1"/>
              <p:nvPr/>
            </p:nvSpPr>
            <p:spPr>
              <a:xfrm>
                <a:off x="4731506" y="243739"/>
                <a:ext cx="171522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GB" sz="1000" b="1"/>
                  <a:t>C</a:t>
                </a:r>
                <a:r>
                  <a:rPr lang="en-GB" sz="1000" b="1" smtClean="0"/>
                  <a:t>m</a:t>
                </a:r>
                <a:endParaRPr lang="en-NZ" sz="1000" b="1"/>
              </a:p>
            </p:txBody>
          </p:sp>
          <p:sp>
            <p:nvSpPr>
              <p:cNvPr id="161" name="Rounded Rectangle 160"/>
              <p:cNvSpPr>
                <a:spLocks noChangeAspect="1"/>
              </p:cNvSpPr>
              <p:nvPr/>
            </p:nvSpPr>
            <p:spPr>
              <a:xfrm>
                <a:off x="4144828" y="246338"/>
                <a:ext cx="786327" cy="340624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Z"/>
              </a:p>
            </p:txBody>
          </p:sp>
          <p:sp>
            <p:nvSpPr>
              <p:cNvPr id="162" name="Bent Arrow 161"/>
              <p:cNvSpPr>
                <a:spLocks noChangeAspect="1"/>
              </p:cNvSpPr>
              <p:nvPr/>
            </p:nvSpPr>
            <p:spPr>
              <a:xfrm>
                <a:off x="4225344" y="405501"/>
                <a:ext cx="98890" cy="181460"/>
              </a:xfrm>
              <a:prstGeom prst="bentArrow">
                <a:avLst/>
              </a:prstGeom>
              <a:solidFill>
                <a:schemeClr val="bg1">
                  <a:lumMod val="8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Z">
                  <a:solidFill>
                    <a:schemeClr val="tx1"/>
                  </a:solidFill>
                </a:endParaRPr>
              </a:p>
            </p:txBody>
          </p:sp>
          <p:sp>
            <p:nvSpPr>
              <p:cNvPr id="163" name="Oval 162"/>
              <p:cNvSpPr/>
              <p:nvPr/>
            </p:nvSpPr>
            <p:spPr>
              <a:xfrm>
                <a:off x="4112083" y="211854"/>
                <a:ext cx="100811" cy="100811"/>
              </a:xfrm>
              <a:prstGeom prst="ellipse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Z"/>
              </a:p>
            </p:txBody>
          </p:sp>
          <p:sp>
            <p:nvSpPr>
              <p:cNvPr id="164" name="Rectangle 163"/>
              <p:cNvSpPr/>
              <p:nvPr/>
            </p:nvSpPr>
            <p:spPr>
              <a:xfrm>
                <a:off x="4270832" y="532771"/>
                <a:ext cx="139638" cy="100811"/>
              </a:xfrm>
              <a:prstGeom prst="rect">
                <a:avLst/>
              </a:prstGeom>
              <a:solidFill>
                <a:schemeClr val="accent6">
                  <a:lumMod val="7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Z"/>
              </a:p>
            </p:txBody>
          </p:sp>
          <p:sp>
            <p:nvSpPr>
              <p:cNvPr id="165" name="Rectangle 164"/>
              <p:cNvSpPr/>
              <p:nvPr/>
            </p:nvSpPr>
            <p:spPr>
              <a:xfrm>
                <a:off x="4408900" y="532771"/>
                <a:ext cx="115213" cy="100811"/>
              </a:xfrm>
              <a:prstGeom prst="rect">
                <a:avLst/>
              </a:prstGeom>
              <a:solidFill>
                <a:schemeClr val="accent6">
                  <a:lumMod val="7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Z"/>
              </a:p>
            </p:txBody>
          </p:sp>
          <p:sp>
            <p:nvSpPr>
              <p:cNvPr id="166" name="Right Arrow 165"/>
              <p:cNvSpPr/>
              <p:nvPr/>
            </p:nvSpPr>
            <p:spPr>
              <a:xfrm>
                <a:off x="4525683" y="482366"/>
                <a:ext cx="144016" cy="201622"/>
              </a:xfrm>
              <a:prstGeom prst="rightArrow">
                <a:avLst/>
              </a:prstGeom>
              <a:solidFill>
                <a:schemeClr val="accent6">
                  <a:lumMod val="7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Z"/>
              </a:p>
            </p:txBody>
          </p:sp>
          <p:sp>
            <p:nvSpPr>
              <p:cNvPr id="167" name="TextBox 166"/>
              <p:cNvSpPr txBox="1"/>
              <p:nvPr/>
            </p:nvSpPr>
            <p:spPr>
              <a:xfrm>
                <a:off x="3936918" y="420658"/>
                <a:ext cx="281674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GB" sz="900" b="1" smtClean="0">
                    <a:latin typeface="Arial" pitchFamily="34" charset="0"/>
                    <a:cs typeface="Arial" pitchFamily="34" charset="0"/>
                  </a:rPr>
                  <a:t>p</a:t>
                </a:r>
                <a:r>
                  <a:rPr lang="en-GB" sz="900" b="1" i="1" smtClean="0">
                    <a:latin typeface="Arial" pitchFamily="34" charset="0"/>
                    <a:cs typeface="Arial" pitchFamily="34" charset="0"/>
                  </a:rPr>
                  <a:t>L</a:t>
                </a:r>
              </a:p>
              <a:p>
                <a:r>
                  <a:rPr lang="en-GB" sz="900" b="1" i="1" smtClean="0">
                    <a:latin typeface="Arial" pitchFamily="34" charset="0"/>
                    <a:cs typeface="Arial" pitchFamily="34" charset="0"/>
                  </a:rPr>
                  <a:t>tetO</a:t>
                </a:r>
                <a:endParaRPr lang="en-NZ" sz="900" b="1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8" name="Right Arrow 167"/>
              <p:cNvSpPr/>
              <p:nvPr/>
            </p:nvSpPr>
            <p:spPr>
              <a:xfrm>
                <a:off x="4669699" y="482366"/>
                <a:ext cx="157034" cy="201622"/>
              </a:xfrm>
              <a:prstGeom prst="rightArrow">
                <a:avLst/>
              </a:prstGeom>
              <a:solidFill>
                <a:srgbClr val="66FF33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Z"/>
              </a:p>
            </p:txBody>
          </p:sp>
        </p:grpSp>
        <p:sp>
          <p:nvSpPr>
            <p:cNvPr id="58" name="Oval 59"/>
            <p:cNvSpPr>
              <a:spLocks noChangeArrowheads="1"/>
            </p:cNvSpPr>
            <p:nvPr/>
          </p:nvSpPr>
          <p:spPr bwMode="auto">
            <a:xfrm>
              <a:off x="5247898" y="3790831"/>
              <a:ext cx="93662" cy="93663"/>
            </a:xfrm>
            <a:prstGeom prst="ellipse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59" name="Oval 60"/>
            <p:cNvSpPr>
              <a:spLocks noChangeArrowheads="1"/>
            </p:cNvSpPr>
            <p:nvPr/>
          </p:nvSpPr>
          <p:spPr bwMode="auto">
            <a:xfrm>
              <a:off x="5797173" y="3955931"/>
              <a:ext cx="93662" cy="93663"/>
            </a:xfrm>
            <a:prstGeom prst="ellipse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60" name="Oval 61"/>
            <p:cNvSpPr>
              <a:spLocks noChangeArrowheads="1"/>
            </p:cNvSpPr>
            <p:nvPr/>
          </p:nvSpPr>
          <p:spPr bwMode="auto">
            <a:xfrm>
              <a:off x="6346448" y="4581406"/>
              <a:ext cx="92075" cy="92075"/>
            </a:xfrm>
            <a:prstGeom prst="ellipse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61" name="Oval 62"/>
            <p:cNvSpPr>
              <a:spLocks noChangeArrowheads="1"/>
            </p:cNvSpPr>
            <p:nvPr/>
          </p:nvSpPr>
          <p:spPr bwMode="auto">
            <a:xfrm>
              <a:off x="6895723" y="5246568"/>
              <a:ext cx="92075" cy="93663"/>
            </a:xfrm>
            <a:prstGeom prst="ellipse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62" name="Oval 63"/>
            <p:cNvSpPr>
              <a:spLocks noChangeArrowheads="1"/>
            </p:cNvSpPr>
            <p:nvPr/>
          </p:nvSpPr>
          <p:spPr bwMode="auto">
            <a:xfrm>
              <a:off x="7443410" y="5314831"/>
              <a:ext cx="93662" cy="93663"/>
            </a:xfrm>
            <a:prstGeom prst="ellipse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65" name="Oval 66"/>
            <p:cNvSpPr>
              <a:spLocks noChangeArrowheads="1"/>
            </p:cNvSpPr>
            <p:nvPr/>
          </p:nvSpPr>
          <p:spPr bwMode="auto">
            <a:xfrm>
              <a:off x="6346448" y="4697293"/>
              <a:ext cx="92075" cy="93663"/>
            </a:xfrm>
            <a:prstGeom prst="ellipse">
              <a:avLst/>
            </a:prstGeom>
            <a:solidFill>
              <a:schemeClr val="bg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66" name="Oval 67"/>
            <p:cNvSpPr>
              <a:spLocks noChangeArrowheads="1"/>
            </p:cNvSpPr>
            <p:nvPr/>
          </p:nvSpPr>
          <p:spPr bwMode="auto">
            <a:xfrm>
              <a:off x="6895723" y="5187831"/>
              <a:ext cx="92075" cy="92075"/>
            </a:xfrm>
            <a:prstGeom prst="ellipse">
              <a:avLst/>
            </a:prstGeom>
            <a:solidFill>
              <a:schemeClr val="bg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67" name="Oval 68"/>
            <p:cNvSpPr>
              <a:spLocks noChangeArrowheads="1"/>
            </p:cNvSpPr>
            <p:nvPr/>
          </p:nvSpPr>
          <p:spPr bwMode="auto">
            <a:xfrm>
              <a:off x="7443410" y="5275143"/>
              <a:ext cx="93662" cy="93663"/>
            </a:xfrm>
            <a:prstGeom prst="ellipse">
              <a:avLst/>
            </a:prstGeom>
            <a:solidFill>
              <a:schemeClr val="bg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83" name="Oval 63"/>
            <p:cNvSpPr>
              <a:spLocks noChangeArrowheads="1"/>
            </p:cNvSpPr>
            <p:nvPr/>
          </p:nvSpPr>
          <p:spPr bwMode="auto">
            <a:xfrm>
              <a:off x="7982516" y="5326244"/>
              <a:ext cx="93662" cy="93663"/>
            </a:xfrm>
            <a:prstGeom prst="ellipse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84" name="Oval 68"/>
            <p:cNvSpPr>
              <a:spLocks noChangeArrowheads="1"/>
            </p:cNvSpPr>
            <p:nvPr/>
          </p:nvSpPr>
          <p:spPr bwMode="auto">
            <a:xfrm>
              <a:off x="7982516" y="5286556"/>
              <a:ext cx="93662" cy="93663"/>
            </a:xfrm>
            <a:prstGeom prst="ellipse">
              <a:avLst/>
            </a:prstGeom>
            <a:solidFill>
              <a:schemeClr val="bg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05" name="Line 106"/>
            <p:cNvSpPr>
              <a:spLocks noChangeShapeType="1"/>
            </p:cNvSpPr>
            <p:nvPr/>
          </p:nvSpPr>
          <p:spPr bwMode="auto">
            <a:xfrm flipH="1">
              <a:off x="5267948" y="3679824"/>
              <a:ext cx="30162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202" name="Rectangle 201"/>
            <p:cNvSpPr/>
            <p:nvPr/>
          </p:nvSpPr>
          <p:spPr>
            <a:xfrm>
              <a:off x="5353623" y="3805884"/>
              <a:ext cx="434648" cy="172219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201" name="Freeform 200"/>
            <p:cNvSpPr/>
            <p:nvPr/>
          </p:nvSpPr>
          <p:spPr>
            <a:xfrm>
              <a:off x="5288016" y="3834586"/>
              <a:ext cx="528957" cy="127114"/>
            </a:xfrm>
            <a:custGeom>
              <a:avLst/>
              <a:gdLst>
                <a:gd name="connsiteX0" fmla="*/ 0 w 528957"/>
                <a:gd name="connsiteY0" fmla="*/ 0 h 127114"/>
                <a:gd name="connsiteX1" fmla="*/ 147616 w 528957"/>
                <a:gd name="connsiteY1" fmla="*/ 4101 h 127114"/>
                <a:gd name="connsiteX2" fmla="*/ 315734 w 528957"/>
                <a:gd name="connsiteY2" fmla="*/ 24603 h 127114"/>
                <a:gd name="connsiteX3" fmla="*/ 471551 w 528957"/>
                <a:gd name="connsiteY3" fmla="*/ 94311 h 127114"/>
                <a:gd name="connsiteX4" fmla="*/ 528957 w 528957"/>
                <a:gd name="connsiteY4" fmla="*/ 127114 h 127114"/>
                <a:gd name="connsiteX5" fmla="*/ 528957 w 528957"/>
                <a:gd name="connsiteY5" fmla="*/ 127114 h 127114"/>
                <a:gd name="connsiteX0" fmla="*/ 0 w 528957"/>
                <a:gd name="connsiteY0" fmla="*/ 0 h 127114"/>
                <a:gd name="connsiteX1" fmla="*/ 147616 w 528957"/>
                <a:gd name="connsiteY1" fmla="*/ 4101 h 127114"/>
                <a:gd name="connsiteX2" fmla="*/ 315734 w 528957"/>
                <a:gd name="connsiteY2" fmla="*/ 24603 h 127114"/>
                <a:gd name="connsiteX3" fmla="*/ 455150 w 528957"/>
                <a:gd name="connsiteY3" fmla="*/ 77909 h 127114"/>
                <a:gd name="connsiteX4" fmla="*/ 528957 w 528957"/>
                <a:gd name="connsiteY4" fmla="*/ 127114 h 127114"/>
                <a:gd name="connsiteX5" fmla="*/ 528957 w 528957"/>
                <a:gd name="connsiteY5" fmla="*/ 127114 h 12711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28957" h="127114">
                  <a:moveTo>
                    <a:pt x="0" y="0"/>
                  </a:moveTo>
                  <a:cubicBezTo>
                    <a:pt x="47497" y="0"/>
                    <a:pt x="94994" y="1"/>
                    <a:pt x="147616" y="4101"/>
                  </a:cubicBezTo>
                  <a:cubicBezTo>
                    <a:pt x="200238" y="8201"/>
                    <a:pt x="264478" y="12302"/>
                    <a:pt x="315734" y="24603"/>
                  </a:cubicBezTo>
                  <a:cubicBezTo>
                    <a:pt x="366990" y="36904"/>
                    <a:pt x="419613" y="60824"/>
                    <a:pt x="455150" y="77909"/>
                  </a:cubicBezTo>
                  <a:cubicBezTo>
                    <a:pt x="490687" y="94994"/>
                    <a:pt x="516656" y="118913"/>
                    <a:pt x="528957" y="127114"/>
                  </a:cubicBezTo>
                  <a:lnTo>
                    <a:pt x="528957" y="127114"/>
                  </a:lnTo>
                </a:path>
              </a:pathLst>
            </a:custGeom>
            <a:ln w="1905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63" name="Oval 64"/>
            <p:cNvSpPr>
              <a:spLocks noChangeArrowheads="1"/>
            </p:cNvSpPr>
            <p:nvPr/>
          </p:nvSpPr>
          <p:spPr bwMode="auto">
            <a:xfrm>
              <a:off x="5247898" y="3790831"/>
              <a:ext cx="93662" cy="93663"/>
            </a:xfrm>
            <a:prstGeom prst="ellipse">
              <a:avLst/>
            </a:prstGeom>
            <a:solidFill>
              <a:schemeClr val="bg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64" name="Oval 65"/>
            <p:cNvSpPr>
              <a:spLocks noChangeArrowheads="1"/>
            </p:cNvSpPr>
            <p:nvPr/>
          </p:nvSpPr>
          <p:spPr bwMode="auto">
            <a:xfrm>
              <a:off x="5797173" y="3908306"/>
              <a:ext cx="93662" cy="93663"/>
            </a:xfrm>
            <a:prstGeom prst="ellipse">
              <a:avLst/>
            </a:prstGeom>
            <a:solidFill>
              <a:schemeClr val="bg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</p:grpSp>
      <p:sp>
        <p:nvSpPr>
          <p:cNvPr id="1755" name="Rectangle 731"/>
          <p:cNvSpPr>
            <a:spLocks noChangeArrowheads="1"/>
          </p:cNvSpPr>
          <p:nvPr/>
        </p:nvSpPr>
        <p:spPr bwMode="auto">
          <a:xfrm>
            <a:off x="871538" y="1308100"/>
            <a:ext cx="3819525" cy="25574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NZ"/>
          </a:p>
        </p:txBody>
      </p:sp>
      <p:grpSp>
        <p:nvGrpSpPr>
          <p:cNvPr id="1020" name="Group 1019"/>
          <p:cNvGrpSpPr/>
          <p:nvPr/>
        </p:nvGrpSpPr>
        <p:grpSpPr>
          <a:xfrm>
            <a:off x="818995" y="1257300"/>
            <a:ext cx="3553092" cy="3018354"/>
            <a:chOff x="818995" y="1257300"/>
            <a:chExt cx="3553092" cy="3018354"/>
          </a:xfrm>
        </p:grpSpPr>
        <p:cxnSp>
          <p:nvCxnSpPr>
            <p:cNvPr id="1008" name="Straight Connector 1007"/>
            <p:cNvCxnSpPr/>
            <p:nvPr/>
          </p:nvCxnSpPr>
          <p:spPr>
            <a:xfrm>
              <a:off x="1424770" y="1530525"/>
              <a:ext cx="268287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6" name="Freeform 1005"/>
            <p:cNvSpPr/>
            <p:nvPr/>
          </p:nvSpPr>
          <p:spPr>
            <a:xfrm>
              <a:off x="1651848" y="1520108"/>
              <a:ext cx="2462952" cy="2348630"/>
            </a:xfrm>
            <a:custGeom>
              <a:avLst/>
              <a:gdLst>
                <a:gd name="connsiteX0" fmla="*/ 0 w 2381250"/>
                <a:gd name="connsiteY0" fmla="*/ 11112 h 2355849"/>
                <a:gd name="connsiteX1" fmla="*/ 238125 w 2381250"/>
                <a:gd name="connsiteY1" fmla="*/ 11112 h 2355849"/>
                <a:gd name="connsiteX2" fmla="*/ 438150 w 2381250"/>
                <a:gd name="connsiteY2" fmla="*/ 77787 h 2355849"/>
                <a:gd name="connsiteX3" fmla="*/ 581025 w 2381250"/>
                <a:gd name="connsiteY3" fmla="*/ 306387 h 2355849"/>
                <a:gd name="connsiteX4" fmla="*/ 1104900 w 2381250"/>
                <a:gd name="connsiteY4" fmla="*/ 1763712 h 2355849"/>
                <a:gd name="connsiteX5" fmla="*/ 1162050 w 2381250"/>
                <a:gd name="connsiteY5" fmla="*/ 1916112 h 2355849"/>
                <a:gd name="connsiteX6" fmla="*/ 1323975 w 2381250"/>
                <a:gd name="connsiteY6" fmla="*/ 2173287 h 2355849"/>
                <a:gd name="connsiteX7" fmla="*/ 1781175 w 2381250"/>
                <a:gd name="connsiteY7" fmla="*/ 2325687 h 2355849"/>
                <a:gd name="connsiteX8" fmla="*/ 2381250 w 2381250"/>
                <a:gd name="connsiteY8" fmla="*/ 2354262 h 2355849"/>
                <a:gd name="connsiteX9" fmla="*/ 2381250 w 2381250"/>
                <a:gd name="connsiteY9" fmla="*/ 2354262 h 2355849"/>
                <a:gd name="connsiteX0" fmla="*/ 0 w 2381250"/>
                <a:gd name="connsiteY0" fmla="*/ 9025 h 2353762"/>
                <a:gd name="connsiteX1" fmla="*/ 238125 w 2381250"/>
                <a:gd name="connsiteY1" fmla="*/ 9025 h 2353762"/>
                <a:gd name="connsiteX2" fmla="*/ 403703 w 2381250"/>
                <a:gd name="connsiteY2" fmla="*/ 63174 h 2353762"/>
                <a:gd name="connsiteX3" fmla="*/ 581025 w 2381250"/>
                <a:gd name="connsiteY3" fmla="*/ 304300 h 2353762"/>
                <a:gd name="connsiteX4" fmla="*/ 1104900 w 2381250"/>
                <a:gd name="connsiteY4" fmla="*/ 1761625 h 2353762"/>
                <a:gd name="connsiteX5" fmla="*/ 1162050 w 2381250"/>
                <a:gd name="connsiteY5" fmla="*/ 1914025 h 2353762"/>
                <a:gd name="connsiteX6" fmla="*/ 1323975 w 2381250"/>
                <a:gd name="connsiteY6" fmla="*/ 2171200 h 2353762"/>
                <a:gd name="connsiteX7" fmla="*/ 1781175 w 2381250"/>
                <a:gd name="connsiteY7" fmla="*/ 2323600 h 2353762"/>
                <a:gd name="connsiteX8" fmla="*/ 2381250 w 2381250"/>
                <a:gd name="connsiteY8" fmla="*/ 2352175 h 2353762"/>
                <a:gd name="connsiteX9" fmla="*/ 2381250 w 2381250"/>
                <a:gd name="connsiteY9" fmla="*/ 2352175 h 2353762"/>
                <a:gd name="connsiteX0" fmla="*/ 0 w 2381250"/>
                <a:gd name="connsiteY0" fmla="*/ 9025 h 2353762"/>
                <a:gd name="connsiteX1" fmla="*/ 238125 w 2381250"/>
                <a:gd name="connsiteY1" fmla="*/ 9025 h 2353762"/>
                <a:gd name="connsiteX2" fmla="*/ 403703 w 2381250"/>
                <a:gd name="connsiteY2" fmla="*/ 63174 h 2353762"/>
                <a:gd name="connsiteX3" fmla="*/ 581025 w 2381250"/>
                <a:gd name="connsiteY3" fmla="*/ 304300 h 2353762"/>
                <a:gd name="connsiteX4" fmla="*/ 1104900 w 2381250"/>
                <a:gd name="connsiteY4" fmla="*/ 1761625 h 2353762"/>
                <a:gd name="connsiteX5" fmla="*/ 1162050 w 2381250"/>
                <a:gd name="connsiteY5" fmla="*/ 1914025 h 2353762"/>
                <a:gd name="connsiteX6" fmla="*/ 1323975 w 2381250"/>
                <a:gd name="connsiteY6" fmla="*/ 2171200 h 2353762"/>
                <a:gd name="connsiteX7" fmla="*/ 1781175 w 2381250"/>
                <a:gd name="connsiteY7" fmla="*/ 2323600 h 2353762"/>
                <a:gd name="connsiteX8" fmla="*/ 2381250 w 2381250"/>
                <a:gd name="connsiteY8" fmla="*/ 2352175 h 2353762"/>
                <a:gd name="connsiteX9" fmla="*/ 2381250 w 2381250"/>
                <a:gd name="connsiteY9" fmla="*/ 2352175 h 2353762"/>
                <a:gd name="connsiteX0" fmla="*/ 0 w 2381250"/>
                <a:gd name="connsiteY0" fmla="*/ 9025 h 2353762"/>
                <a:gd name="connsiteX1" fmla="*/ 238125 w 2381250"/>
                <a:gd name="connsiteY1" fmla="*/ 9025 h 2353762"/>
                <a:gd name="connsiteX2" fmla="*/ 403703 w 2381250"/>
                <a:gd name="connsiteY2" fmla="*/ 63174 h 2353762"/>
                <a:gd name="connsiteX3" fmla="*/ 602946 w 2381250"/>
                <a:gd name="connsiteY3" fmla="*/ 370061 h 2353762"/>
                <a:gd name="connsiteX4" fmla="*/ 1104900 w 2381250"/>
                <a:gd name="connsiteY4" fmla="*/ 1761625 h 2353762"/>
                <a:gd name="connsiteX5" fmla="*/ 1162050 w 2381250"/>
                <a:gd name="connsiteY5" fmla="*/ 1914025 h 2353762"/>
                <a:gd name="connsiteX6" fmla="*/ 1323975 w 2381250"/>
                <a:gd name="connsiteY6" fmla="*/ 2171200 h 2353762"/>
                <a:gd name="connsiteX7" fmla="*/ 1781175 w 2381250"/>
                <a:gd name="connsiteY7" fmla="*/ 2323600 h 2353762"/>
                <a:gd name="connsiteX8" fmla="*/ 2381250 w 2381250"/>
                <a:gd name="connsiteY8" fmla="*/ 2352175 h 2353762"/>
                <a:gd name="connsiteX9" fmla="*/ 2381250 w 2381250"/>
                <a:gd name="connsiteY9" fmla="*/ 2352175 h 2353762"/>
                <a:gd name="connsiteX0" fmla="*/ 0 w 2381250"/>
                <a:gd name="connsiteY0" fmla="*/ 7459 h 2352196"/>
                <a:gd name="connsiteX1" fmla="*/ 238125 w 2381250"/>
                <a:gd name="connsiteY1" fmla="*/ 7459 h 2352196"/>
                <a:gd name="connsiteX2" fmla="*/ 403703 w 2381250"/>
                <a:gd name="connsiteY2" fmla="*/ 52213 h 2352196"/>
                <a:gd name="connsiteX3" fmla="*/ 602946 w 2381250"/>
                <a:gd name="connsiteY3" fmla="*/ 368495 h 2352196"/>
                <a:gd name="connsiteX4" fmla="*/ 1104900 w 2381250"/>
                <a:gd name="connsiteY4" fmla="*/ 1760059 h 2352196"/>
                <a:gd name="connsiteX5" fmla="*/ 1162050 w 2381250"/>
                <a:gd name="connsiteY5" fmla="*/ 1912459 h 2352196"/>
                <a:gd name="connsiteX6" fmla="*/ 1323975 w 2381250"/>
                <a:gd name="connsiteY6" fmla="*/ 2169634 h 2352196"/>
                <a:gd name="connsiteX7" fmla="*/ 1781175 w 2381250"/>
                <a:gd name="connsiteY7" fmla="*/ 2322034 h 2352196"/>
                <a:gd name="connsiteX8" fmla="*/ 2381250 w 2381250"/>
                <a:gd name="connsiteY8" fmla="*/ 2350609 h 2352196"/>
                <a:gd name="connsiteX9" fmla="*/ 2381250 w 2381250"/>
                <a:gd name="connsiteY9" fmla="*/ 2350609 h 2352196"/>
                <a:gd name="connsiteX0" fmla="*/ 0 w 2381250"/>
                <a:gd name="connsiteY0" fmla="*/ 7459 h 2352196"/>
                <a:gd name="connsiteX1" fmla="*/ 238125 w 2381250"/>
                <a:gd name="connsiteY1" fmla="*/ 7459 h 2352196"/>
                <a:gd name="connsiteX2" fmla="*/ 403703 w 2381250"/>
                <a:gd name="connsiteY2" fmla="*/ 52213 h 2352196"/>
                <a:gd name="connsiteX3" fmla="*/ 602946 w 2381250"/>
                <a:gd name="connsiteY3" fmla="*/ 368495 h 2352196"/>
                <a:gd name="connsiteX4" fmla="*/ 1104900 w 2381250"/>
                <a:gd name="connsiteY4" fmla="*/ 1760059 h 2352196"/>
                <a:gd name="connsiteX5" fmla="*/ 1162050 w 2381250"/>
                <a:gd name="connsiteY5" fmla="*/ 1912459 h 2352196"/>
                <a:gd name="connsiteX6" fmla="*/ 1323975 w 2381250"/>
                <a:gd name="connsiteY6" fmla="*/ 2169634 h 2352196"/>
                <a:gd name="connsiteX7" fmla="*/ 1781175 w 2381250"/>
                <a:gd name="connsiteY7" fmla="*/ 2322034 h 2352196"/>
                <a:gd name="connsiteX8" fmla="*/ 2381250 w 2381250"/>
                <a:gd name="connsiteY8" fmla="*/ 2350609 h 2352196"/>
                <a:gd name="connsiteX9" fmla="*/ 2381250 w 2381250"/>
                <a:gd name="connsiteY9" fmla="*/ 2350609 h 2352196"/>
                <a:gd name="connsiteX0" fmla="*/ 0 w 2381250"/>
                <a:gd name="connsiteY0" fmla="*/ 10591 h 2355328"/>
                <a:gd name="connsiteX1" fmla="*/ 216204 w 2381250"/>
                <a:gd name="connsiteY1" fmla="*/ 7459 h 2355328"/>
                <a:gd name="connsiteX2" fmla="*/ 403703 w 2381250"/>
                <a:gd name="connsiteY2" fmla="*/ 55345 h 2355328"/>
                <a:gd name="connsiteX3" fmla="*/ 602946 w 2381250"/>
                <a:gd name="connsiteY3" fmla="*/ 371627 h 2355328"/>
                <a:gd name="connsiteX4" fmla="*/ 1104900 w 2381250"/>
                <a:gd name="connsiteY4" fmla="*/ 1763191 h 2355328"/>
                <a:gd name="connsiteX5" fmla="*/ 1162050 w 2381250"/>
                <a:gd name="connsiteY5" fmla="*/ 1915591 h 2355328"/>
                <a:gd name="connsiteX6" fmla="*/ 1323975 w 2381250"/>
                <a:gd name="connsiteY6" fmla="*/ 2172766 h 2355328"/>
                <a:gd name="connsiteX7" fmla="*/ 1781175 w 2381250"/>
                <a:gd name="connsiteY7" fmla="*/ 2325166 h 2355328"/>
                <a:gd name="connsiteX8" fmla="*/ 2381250 w 2381250"/>
                <a:gd name="connsiteY8" fmla="*/ 2353741 h 2355328"/>
                <a:gd name="connsiteX9" fmla="*/ 2381250 w 2381250"/>
                <a:gd name="connsiteY9" fmla="*/ 2353741 h 2355328"/>
                <a:gd name="connsiteX0" fmla="*/ 0 w 2381250"/>
                <a:gd name="connsiteY0" fmla="*/ 9025 h 2353762"/>
                <a:gd name="connsiteX1" fmla="*/ 216204 w 2381250"/>
                <a:gd name="connsiteY1" fmla="*/ 5893 h 2353762"/>
                <a:gd name="connsiteX2" fmla="*/ 406835 w 2381250"/>
                <a:gd name="connsiteY2" fmla="*/ 44385 h 2353762"/>
                <a:gd name="connsiteX3" fmla="*/ 602946 w 2381250"/>
                <a:gd name="connsiteY3" fmla="*/ 370061 h 2353762"/>
                <a:gd name="connsiteX4" fmla="*/ 1104900 w 2381250"/>
                <a:gd name="connsiteY4" fmla="*/ 1761625 h 2353762"/>
                <a:gd name="connsiteX5" fmla="*/ 1162050 w 2381250"/>
                <a:gd name="connsiteY5" fmla="*/ 1914025 h 2353762"/>
                <a:gd name="connsiteX6" fmla="*/ 1323975 w 2381250"/>
                <a:gd name="connsiteY6" fmla="*/ 2171200 h 2353762"/>
                <a:gd name="connsiteX7" fmla="*/ 1781175 w 2381250"/>
                <a:gd name="connsiteY7" fmla="*/ 2323600 h 2353762"/>
                <a:gd name="connsiteX8" fmla="*/ 2381250 w 2381250"/>
                <a:gd name="connsiteY8" fmla="*/ 2352175 h 2353762"/>
                <a:gd name="connsiteX9" fmla="*/ 2381250 w 2381250"/>
                <a:gd name="connsiteY9" fmla="*/ 2352175 h 2353762"/>
                <a:gd name="connsiteX0" fmla="*/ 79614 w 2460864"/>
                <a:gd name="connsiteY0" fmla="*/ 8069 h 2352806"/>
                <a:gd name="connsiteX1" fmla="*/ 36034 w 2460864"/>
                <a:gd name="connsiteY1" fmla="*/ 13809 h 2352806"/>
                <a:gd name="connsiteX2" fmla="*/ 295818 w 2460864"/>
                <a:gd name="connsiteY2" fmla="*/ 4937 h 2352806"/>
                <a:gd name="connsiteX3" fmla="*/ 486449 w 2460864"/>
                <a:gd name="connsiteY3" fmla="*/ 43429 h 2352806"/>
                <a:gd name="connsiteX4" fmla="*/ 682560 w 2460864"/>
                <a:gd name="connsiteY4" fmla="*/ 369105 h 2352806"/>
                <a:gd name="connsiteX5" fmla="*/ 1184514 w 2460864"/>
                <a:gd name="connsiteY5" fmla="*/ 1760669 h 2352806"/>
                <a:gd name="connsiteX6" fmla="*/ 1241664 w 2460864"/>
                <a:gd name="connsiteY6" fmla="*/ 1913069 h 2352806"/>
                <a:gd name="connsiteX7" fmla="*/ 1403589 w 2460864"/>
                <a:gd name="connsiteY7" fmla="*/ 2170244 h 2352806"/>
                <a:gd name="connsiteX8" fmla="*/ 1860789 w 2460864"/>
                <a:gd name="connsiteY8" fmla="*/ 2322644 h 2352806"/>
                <a:gd name="connsiteX9" fmla="*/ 2460864 w 2460864"/>
                <a:gd name="connsiteY9" fmla="*/ 2351219 h 2352806"/>
                <a:gd name="connsiteX10" fmla="*/ 2460864 w 2460864"/>
                <a:gd name="connsiteY10" fmla="*/ 2351219 h 2352806"/>
                <a:gd name="connsiteX0" fmla="*/ 81702 w 2462952"/>
                <a:gd name="connsiteY0" fmla="*/ 7589 h 2352326"/>
                <a:gd name="connsiteX1" fmla="*/ 38122 w 2462952"/>
                <a:gd name="connsiteY1" fmla="*/ 13329 h 2352326"/>
                <a:gd name="connsiteX2" fmla="*/ 310432 w 2462952"/>
                <a:gd name="connsiteY2" fmla="*/ 10720 h 2352326"/>
                <a:gd name="connsiteX3" fmla="*/ 488537 w 2462952"/>
                <a:gd name="connsiteY3" fmla="*/ 42949 h 2352326"/>
                <a:gd name="connsiteX4" fmla="*/ 684648 w 2462952"/>
                <a:gd name="connsiteY4" fmla="*/ 368625 h 2352326"/>
                <a:gd name="connsiteX5" fmla="*/ 1186602 w 2462952"/>
                <a:gd name="connsiteY5" fmla="*/ 1760189 h 2352326"/>
                <a:gd name="connsiteX6" fmla="*/ 1243752 w 2462952"/>
                <a:gd name="connsiteY6" fmla="*/ 1912589 h 2352326"/>
                <a:gd name="connsiteX7" fmla="*/ 1405677 w 2462952"/>
                <a:gd name="connsiteY7" fmla="*/ 2169764 h 2352326"/>
                <a:gd name="connsiteX8" fmla="*/ 1862877 w 2462952"/>
                <a:gd name="connsiteY8" fmla="*/ 2322164 h 2352326"/>
                <a:gd name="connsiteX9" fmla="*/ 2462952 w 2462952"/>
                <a:gd name="connsiteY9" fmla="*/ 2350739 h 2352326"/>
                <a:gd name="connsiteX10" fmla="*/ 2462952 w 2462952"/>
                <a:gd name="connsiteY10" fmla="*/ 2350739 h 2352326"/>
                <a:gd name="connsiteX0" fmla="*/ 81702 w 2462952"/>
                <a:gd name="connsiteY0" fmla="*/ 3893 h 2348630"/>
                <a:gd name="connsiteX1" fmla="*/ 38122 w 2462952"/>
                <a:gd name="connsiteY1" fmla="*/ 9633 h 2348630"/>
                <a:gd name="connsiteX2" fmla="*/ 310432 w 2462952"/>
                <a:gd name="connsiteY2" fmla="*/ 7024 h 2348630"/>
                <a:gd name="connsiteX3" fmla="*/ 469748 w 2462952"/>
                <a:gd name="connsiteY3" fmla="*/ 51779 h 2348630"/>
                <a:gd name="connsiteX4" fmla="*/ 684648 w 2462952"/>
                <a:gd name="connsiteY4" fmla="*/ 364929 h 2348630"/>
                <a:gd name="connsiteX5" fmla="*/ 1186602 w 2462952"/>
                <a:gd name="connsiteY5" fmla="*/ 1756493 h 2348630"/>
                <a:gd name="connsiteX6" fmla="*/ 1243752 w 2462952"/>
                <a:gd name="connsiteY6" fmla="*/ 1908893 h 2348630"/>
                <a:gd name="connsiteX7" fmla="*/ 1405677 w 2462952"/>
                <a:gd name="connsiteY7" fmla="*/ 2166068 h 2348630"/>
                <a:gd name="connsiteX8" fmla="*/ 1862877 w 2462952"/>
                <a:gd name="connsiteY8" fmla="*/ 2318468 h 2348630"/>
                <a:gd name="connsiteX9" fmla="*/ 2462952 w 2462952"/>
                <a:gd name="connsiteY9" fmla="*/ 2347043 h 2348630"/>
                <a:gd name="connsiteX10" fmla="*/ 2462952 w 2462952"/>
                <a:gd name="connsiteY10" fmla="*/ 2347043 h 2348630"/>
                <a:gd name="connsiteX0" fmla="*/ 81702 w 2462952"/>
                <a:gd name="connsiteY0" fmla="*/ 3893 h 2348630"/>
                <a:gd name="connsiteX1" fmla="*/ 38122 w 2462952"/>
                <a:gd name="connsiteY1" fmla="*/ 9633 h 2348630"/>
                <a:gd name="connsiteX2" fmla="*/ 310432 w 2462952"/>
                <a:gd name="connsiteY2" fmla="*/ 7024 h 2348630"/>
                <a:gd name="connsiteX3" fmla="*/ 469748 w 2462952"/>
                <a:gd name="connsiteY3" fmla="*/ 51779 h 2348630"/>
                <a:gd name="connsiteX4" fmla="*/ 564215 w 2462952"/>
                <a:gd name="connsiteY4" fmla="*/ 141156 h 2348630"/>
                <a:gd name="connsiteX5" fmla="*/ 684648 w 2462952"/>
                <a:gd name="connsiteY5" fmla="*/ 364929 h 2348630"/>
                <a:gd name="connsiteX6" fmla="*/ 1186602 w 2462952"/>
                <a:gd name="connsiteY6" fmla="*/ 1756493 h 2348630"/>
                <a:gd name="connsiteX7" fmla="*/ 1243752 w 2462952"/>
                <a:gd name="connsiteY7" fmla="*/ 1908893 h 2348630"/>
                <a:gd name="connsiteX8" fmla="*/ 1405677 w 2462952"/>
                <a:gd name="connsiteY8" fmla="*/ 2166068 h 2348630"/>
                <a:gd name="connsiteX9" fmla="*/ 1862877 w 2462952"/>
                <a:gd name="connsiteY9" fmla="*/ 2318468 h 2348630"/>
                <a:gd name="connsiteX10" fmla="*/ 2462952 w 2462952"/>
                <a:gd name="connsiteY10" fmla="*/ 2347043 h 2348630"/>
                <a:gd name="connsiteX11" fmla="*/ 2462952 w 2462952"/>
                <a:gd name="connsiteY11" fmla="*/ 2347043 h 2348630"/>
                <a:gd name="connsiteX0" fmla="*/ 81702 w 2462952"/>
                <a:gd name="connsiteY0" fmla="*/ 3893 h 2348630"/>
                <a:gd name="connsiteX1" fmla="*/ 38122 w 2462952"/>
                <a:gd name="connsiteY1" fmla="*/ 9633 h 2348630"/>
                <a:gd name="connsiteX2" fmla="*/ 310432 w 2462952"/>
                <a:gd name="connsiteY2" fmla="*/ 7024 h 2348630"/>
                <a:gd name="connsiteX3" fmla="*/ 469748 w 2462952"/>
                <a:gd name="connsiteY3" fmla="*/ 51779 h 2348630"/>
                <a:gd name="connsiteX4" fmla="*/ 564215 w 2462952"/>
                <a:gd name="connsiteY4" fmla="*/ 141156 h 2348630"/>
                <a:gd name="connsiteX5" fmla="*/ 684648 w 2462952"/>
                <a:gd name="connsiteY5" fmla="*/ 368060 h 2348630"/>
                <a:gd name="connsiteX6" fmla="*/ 1186602 w 2462952"/>
                <a:gd name="connsiteY6" fmla="*/ 1756493 h 2348630"/>
                <a:gd name="connsiteX7" fmla="*/ 1243752 w 2462952"/>
                <a:gd name="connsiteY7" fmla="*/ 1908893 h 2348630"/>
                <a:gd name="connsiteX8" fmla="*/ 1405677 w 2462952"/>
                <a:gd name="connsiteY8" fmla="*/ 2166068 h 2348630"/>
                <a:gd name="connsiteX9" fmla="*/ 1862877 w 2462952"/>
                <a:gd name="connsiteY9" fmla="*/ 2318468 h 2348630"/>
                <a:gd name="connsiteX10" fmla="*/ 2462952 w 2462952"/>
                <a:gd name="connsiteY10" fmla="*/ 2347043 h 2348630"/>
                <a:gd name="connsiteX11" fmla="*/ 2462952 w 2462952"/>
                <a:gd name="connsiteY11" fmla="*/ 2347043 h 2348630"/>
                <a:gd name="connsiteX0" fmla="*/ 81702 w 2462952"/>
                <a:gd name="connsiteY0" fmla="*/ 3893 h 2348630"/>
                <a:gd name="connsiteX1" fmla="*/ 38122 w 2462952"/>
                <a:gd name="connsiteY1" fmla="*/ 9633 h 2348630"/>
                <a:gd name="connsiteX2" fmla="*/ 310432 w 2462952"/>
                <a:gd name="connsiteY2" fmla="*/ 7024 h 2348630"/>
                <a:gd name="connsiteX3" fmla="*/ 469748 w 2462952"/>
                <a:gd name="connsiteY3" fmla="*/ 51779 h 2348630"/>
                <a:gd name="connsiteX4" fmla="*/ 564215 w 2462952"/>
                <a:gd name="connsiteY4" fmla="*/ 141156 h 2348630"/>
                <a:gd name="connsiteX5" fmla="*/ 684648 w 2462952"/>
                <a:gd name="connsiteY5" fmla="*/ 368060 h 2348630"/>
                <a:gd name="connsiteX6" fmla="*/ 1186602 w 2462952"/>
                <a:gd name="connsiteY6" fmla="*/ 1756493 h 2348630"/>
                <a:gd name="connsiteX7" fmla="*/ 1243752 w 2462952"/>
                <a:gd name="connsiteY7" fmla="*/ 1908893 h 2348630"/>
                <a:gd name="connsiteX8" fmla="*/ 1405677 w 2462952"/>
                <a:gd name="connsiteY8" fmla="*/ 2166068 h 2348630"/>
                <a:gd name="connsiteX9" fmla="*/ 1862877 w 2462952"/>
                <a:gd name="connsiteY9" fmla="*/ 2318468 h 2348630"/>
                <a:gd name="connsiteX10" fmla="*/ 2462952 w 2462952"/>
                <a:gd name="connsiteY10" fmla="*/ 2347043 h 2348630"/>
                <a:gd name="connsiteX11" fmla="*/ 2462952 w 2462952"/>
                <a:gd name="connsiteY11" fmla="*/ 2347043 h 234863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2462952" h="2348630">
                  <a:moveTo>
                    <a:pt x="81702" y="3893"/>
                  </a:moveTo>
                  <a:cubicBezTo>
                    <a:pt x="82789" y="4328"/>
                    <a:pt x="0" y="9111"/>
                    <a:pt x="38122" y="9633"/>
                  </a:cubicBezTo>
                  <a:cubicBezTo>
                    <a:pt x="76244" y="10155"/>
                    <a:pt x="238494" y="0"/>
                    <a:pt x="310432" y="7024"/>
                  </a:cubicBezTo>
                  <a:cubicBezTo>
                    <a:pt x="382370" y="14048"/>
                    <a:pt x="427451" y="29424"/>
                    <a:pt x="469748" y="51779"/>
                  </a:cubicBezTo>
                  <a:cubicBezTo>
                    <a:pt x="512045" y="74134"/>
                    <a:pt x="528398" y="88442"/>
                    <a:pt x="564215" y="141156"/>
                  </a:cubicBezTo>
                  <a:cubicBezTo>
                    <a:pt x="600032" y="193870"/>
                    <a:pt x="562128" y="108231"/>
                    <a:pt x="684648" y="368060"/>
                  </a:cubicBezTo>
                  <a:cubicBezTo>
                    <a:pt x="788379" y="637283"/>
                    <a:pt x="1093418" y="1499688"/>
                    <a:pt x="1186602" y="1756493"/>
                  </a:cubicBezTo>
                  <a:cubicBezTo>
                    <a:pt x="1279786" y="2013298"/>
                    <a:pt x="1207240" y="1840631"/>
                    <a:pt x="1243752" y="1908893"/>
                  </a:cubicBezTo>
                  <a:cubicBezTo>
                    <a:pt x="1280264" y="1977155"/>
                    <a:pt x="1302490" y="2097806"/>
                    <a:pt x="1405677" y="2166068"/>
                  </a:cubicBezTo>
                  <a:cubicBezTo>
                    <a:pt x="1508865" y="2234331"/>
                    <a:pt x="1686665" y="2288306"/>
                    <a:pt x="1862877" y="2318468"/>
                  </a:cubicBezTo>
                  <a:cubicBezTo>
                    <a:pt x="2039089" y="2348630"/>
                    <a:pt x="2462952" y="2347043"/>
                    <a:pt x="2462952" y="2347043"/>
                  </a:cubicBezTo>
                  <a:lnTo>
                    <a:pt x="2462952" y="2347043"/>
                  </a:lnTo>
                </a:path>
              </a:pathLst>
            </a:cu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1777" name="Line 753"/>
            <p:cNvSpPr>
              <a:spLocks noChangeShapeType="1"/>
            </p:cNvSpPr>
            <p:nvPr/>
          </p:nvSpPr>
          <p:spPr bwMode="auto">
            <a:xfrm flipV="1">
              <a:off x="1419225" y="3867150"/>
              <a:ext cx="280987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grpSp>
          <p:nvGrpSpPr>
            <p:cNvPr id="114" name="Group 172"/>
            <p:cNvGrpSpPr>
              <a:grpSpLocks noChangeAspect="1"/>
            </p:cNvGrpSpPr>
            <p:nvPr/>
          </p:nvGrpSpPr>
          <p:grpSpPr>
            <a:xfrm>
              <a:off x="1526172" y="3313912"/>
              <a:ext cx="996313" cy="485770"/>
              <a:chOff x="745122" y="1513687"/>
              <a:chExt cx="1245391" cy="607213"/>
            </a:xfrm>
          </p:grpSpPr>
          <p:sp>
            <p:nvSpPr>
              <p:cNvPr id="115" name="Rounded Rectangle 114"/>
              <p:cNvSpPr>
                <a:spLocks noChangeAspect="1"/>
              </p:cNvSpPr>
              <p:nvPr/>
            </p:nvSpPr>
            <p:spPr>
              <a:xfrm>
                <a:off x="1007604" y="1556792"/>
                <a:ext cx="982909" cy="425780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Z"/>
              </a:p>
            </p:txBody>
          </p:sp>
          <p:sp>
            <p:nvSpPr>
              <p:cNvPr id="116" name="Bent Arrow 115"/>
              <p:cNvSpPr>
                <a:spLocks noChangeAspect="1"/>
              </p:cNvSpPr>
              <p:nvPr/>
            </p:nvSpPr>
            <p:spPr>
              <a:xfrm>
                <a:off x="1108249" y="1755746"/>
                <a:ext cx="123613" cy="226825"/>
              </a:xfrm>
              <a:prstGeom prst="bentArrow">
                <a:avLst/>
              </a:prstGeom>
              <a:solidFill>
                <a:schemeClr val="bg1">
                  <a:lumMod val="8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Z">
                  <a:solidFill>
                    <a:schemeClr val="tx1"/>
                  </a:solidFill>
                </a:endParaRPr>
              </a:p>
            </p:txBody>
          </p:sp>
          <p:sp>
            <p:nvSpPr>
              <p:cNvPr id="117" name="Oval 116"/>
              <p:cNvSpPr/>
              <p:nvPr/>
            </p:nvSpPr>
            <p:spPr>
              <a:xfrm>
                <a:off x="966673" y="1513687"/>
                <a:ext cx="126014" cy="126014"/>
              </a:xfrm>
              <a:prstGeom prst="ellipse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Z"/>
              </a:p>
            </p:txBody>
          </p:sp>
          <p:sp>
            <p:nvSpPr>
              <p:cNvPr id="118" name="TextBox 117"/>
              <p:cNvSpPr txBox="1"/>
              <p:nvPr/>
            </p:nvSpPr>
            <p:spPr>
              <a:xfrm>
                <a:off x="745122" y="1777218"/>
                <a:ext cx="336630" cy="19236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GB" sz="1000" b="1" smtClean="0">
                    <a:latin typeface="Arial" pitchFamily="34" charset="0"/>
                    <a:cs typeface="Arial" pitchFamily="34" charset="0"/>
                  </a:rPr>
                  <a:t>p</a:t>
                </a:r>
                <a:r>
                  <a:rPr lang="en-GB" sz="1000" b="1" i="1" smtClean="0">
                    <a:latin typeface="Arial" pitchFamily="34" charset="0"/>
                    <a:cs typeface="Arial" pitchFamily="34" charset="0"/>
                  </a:rPr>
                  <a:t>ara</a:t>
                </a:r>
                <a:endParaRPr lang="en-NZ" sz="1000" b="1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9" name="Rectangle 118"/>
              <p:cNvSpPr/>
              <p:nvPr/>
            </p:nvSpPr>
            <p:spPr>
              <a:xfrm>
                <a:off x="1165110" y="1914834"/>
                <a:ext cx="174548" cy="126014"/>
              </a:xfrm>
              <a:prstGeom prst="rect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Z"/>
              </a:p>
            </p:txBody>
          </p:sp>
          <p:sp>
            <p:nvSpPr>
              <p:cNvPr id="120" name="Rectangle 119"/>
              <p:cNvSpPr/>
              <p:nvPr/>
            </p:nvSpPr>
            <p:spPr>
              <a:xfrm>
                <a:off x="1337694" y="1914834"/>
                <a:ext cx="144016" cy="126014"/>
              </a:xfrm>
              <a:prstGeom prst="rect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Z"/>
              </a:p>
            </p:txBody>
          </p:sp>
          <p:sp>
            <p:nvSpPr>
              <p:cNvPr id="121" name="Right Arrow 120"/>
              <p:cNvSpPr/>
              <p:nvPr/>
            </p:nvSpPr>
            <p:spPr>
              <a:xfrm>
                <a:off x="1483673" y="1851827"/>
                <a:ext cx="180020" cy="252028"/>
              </a:xfrm>
              <a:prstGeom prst="rightArrow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Z"/>
              </a:p>
            </p:txBody>
          </p:sp>
          <p:sp>
            <p:nvSpPr>
              <p:cNvPr id="122" name="TextBox 121"/>
              <p:cNvSpPr txBox="1"/>
              <p:nvPr/>
            </p:nvSpPr>
            <p:spPr>
              <a:xfrm>
                <a:off x="1115616" y="1556792"/>
                <a:ext cx="254477" cy="192360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GB" sz="1000" b="1" smtClean="0">
                    <a:cs typeface="Arial" pitchFamily="34" charset="0"/>
                  </a:rPr>
                  <a:t>pP1</a:t>
                </a:r>
                <a:endParaRPr lang="en-NZ" sz="1000" b="1">
                  <a:cs typeface="Arial" pitchFamily="34" charset="0"/>
                </a:endParaRPr>
              </a:p>
            </p:txBody>
          </p:sp>
          <p:sp>
            <p:nvSpPr>
              <p:cNvPr id="123" name="TextBox 122"/>
              <p:cNvSpPr txBox="1"/>
              <p:nvPr/>
            </p:nvSpPr>
            <p:spPr>
              <a:xfrm>
                <a:off x="1697592" y="1566098"/>
                <a:ext cx="214402" cy="192360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GB" sz="1000" b="1" smtClean="0">
                    <a:cs typeface="Arial" pitchFamily="34" charset="0"/>
                  </a:rPr>
                  <a:t>Cm</a:t>
                </a:r>
                <a:endParaRPr lang="en-NZ" sz="1000" b="1">
                  <a:cs typeface="Arial" pitchFamily="34" charset="0"/>
                </a:endParaRPr>
              </a:p>
            </p:txBody>
          </p:sp>
          <p:sp>
            <p:nvSpPr>
              <p:cNvPr id="124" name="Right Arrow 123"/>
              <p:cNvSpPr/>
              <p:nvPr/>
            </p:nvSpPr>
            <p:spPr>
              <a:xfrm>
                <a:off x="1671103" y="1851580"/>
                <a:ext cx="196292" cy="252028"/>
              </a:xfrm>
              <a:prstGeom prst="rightArrow">
                <a:avLst/>
              </a:prstGeom>
              <a:solidFill>
                <a:srgbClr val="66FF33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Z"/>
              </a:p>
            </p:txBody>
          </p:sp>
          <p:sp>
            <p:nvSpPr>
              <p:cNvPr id="125" name="Left Bracket 124"/>
              <p:cNvSpPr/>
              <p:nvPr/>
            </p:nvSpPr>
            <p:spPr>
              <a:xfrm>
                <a:off x="1663700" y="1841500"/>
                <a:ext cx="45719" cy="27940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NZ"/>
              </a:p>
            </p:txBody>
          </p:sp>
          <p:sp>
            <p:nvSpPr>
              <p:cNvPr id="126" name="Left Bracket 125"/>
              <p:cNvSpPr/>
              <p:nvPr/>
            </p:nvSpPr>
            <p:spPr>
              <a:xfrm flipH="1">
                <a:off x="1835150" y="1835150"/>
                <a:ext cx="45719" cy="27940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NZ"/>
              </a:p>
            </p:txBody>
          </p:sp>
        </p:grpSp>
        <p:sp>
          <p:nvSpPr>
            <p:cNvPr id="1780" name="Line 756"/>
            <p:cNvSpPr>
              <a:spLocks noChangeShapeType="1"/>
            </p:cNvSpPr>
            <p:nvPr/>
          </p:nvSpPr>
          <p:spPr bwMode="auto">
            <a:xfrm>
              <a:off x="1428750" y="3854450"/>
              <a:ext cx="1588" cy="73025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81" name="Rectangle 757"/>
            <p:cNvSpPr>
              <a:spLocks noChangeArrowheads="1"/>
            </p:cNvSpPr>
            <p:nvPr/>
          </p:nvSpPr>
          <p:spPr bwMode="auto">
            <a:xfrm>
              <a:off x="1384300" y="3924300"/>
              <a:ext cx="8496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82" name="Line 758"/>
            <p:cNvSpPr>
              <a:spLocks noChangeShapeType="1"/>
            </p:cNvSpPr>
            <p:nvPr/>
          </p:nvSpPr>
          <p:spPr bwMode="auto">
            <a:xfrm>
              <a:off x="1985963" y="3854450"/>
              <a:ext cx="1588" cy="73025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83" name="Rectangle 759"/>
            <p:cNvSpPr>
              <a:spLocks noChangeArrowheads="1"/>
            </p:cNvSpPr>
            <p:nvPr/>
          </p:nvSpPr>
          <p:spPr bwMode="auto">
            <a:xfrm>
              <a:off x="1892300" y="3924300"/>
              <a:ext cx="21320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1</a:t>
              </a:r>
              <a:endParaRPr kumimoji="0" 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84" name="Line 760"/>
            <p:cNvSpPr>
              <a:spLocks noChangeShapeType="1"/>
            </p:cNvSpPr>
            <p:nvPr/>
          </p:nvSpPr>
          <p:spPr bwMode="auto">
            <a:xfrm>
              <a:off x="2544763" y="3854450"/>
              <a:ext cx="1588" cy="73025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85" name="Rectangle 761"/>
            <p:cNvSpPr>
              <a:spLocks noChangeArrowheads="1"/>
            </p:cNvSpPr>
            <p:nvPr/>
          </p:nvSpPr>
          <p:spPr bwMode="auto">
            <a:xfrm>
              <a:off x="2506663" y="3924300"/>
              <a:ext cx="8496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</a:t>
              </a:r>
              <a:endParaRPr kumimoji="0" 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86" name="Line 762"/>
            <p:cNvSpPr>
              <a:spLocks noChangeShapeType="1"/>
            </p:cNvSpPr>
            <p:nvPr/>
          </p:nvSpPr>
          <p:spPr bwMode="auto">
            <a:xfrm>
              <a:off x="3101975" y="3854450"/>
              <a:ext cx="1588" cy="73025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87" name="Rectangle 763"/>
            <p:cNvSpPr>
              <a:spLocks noChangeArrowheads="1"/>
            </p:cNvSpPr>
            <p:nvPr/>
          </p:nvSpPr>
          <p:spPr bwMode="auto">
            <a:xfrm>
              <a:off x="3017838" y="3924300"/>
              <a:ext cx="169918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</a:t>
              </a:r>
              <a:endParaRPr kumimoji="0" 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88" name="Line 764"/>
            <p:cNvSpPr>
              <a:spLocks noChangeShapeType="1"/>
            </p:cNvSpPr>
            <p:nvPr/>
          </p:nvSpPr>
          <p:spPr bwMode="auto">
            <a:xfrm>
              <a:off x="3660775" y="3854450"/>
              <a:ext cx="1588" cy="73025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89" name="Rectangle 765"/>
            <p:cNvSpPr>
              <a:spLocks noChangeArrowheads="1"/>
            </p:cNvSpPr>
            <p:nvPr/>
          </p:nvSpPr>
          <p:spPr bwMode="auto">
            <a:xfrm>
              <a:off x="3538538" y="3924300"/>
              <a:ext cx="254878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90" name="Line 766"/>
            <p:cNvSpPr>
              <a:spLocks noChangeShapeType="1"/>
            </p:cNvSpPr>
            <p:nvPr/>
          </p:nvSpPr>
          <p:spPr bwMode="auto">
            <a:xfrm>
              <a:off x="4219575" y="3854450"/>
              <a:ext cx="1588" cy="73025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91" name="Rectangle 767"/>
            <p:cNvSpPr>
              <a:spLocks noChangeArrowheads="1"/>
            </p:cNvSpPr>
            <p:nvPr/>
          </p:nvSpPr>
          <p:spPr bwMode="auto">
            <a:xfrm>
              <a:off x="4032250" y="3924300"/>
              <a:ext cx="339837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0</a:t>
              </a:r>
              <a:endParaRPr kumimoji="0" 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78" name="Line 754"/>
            <p:cNvSpPr>
              <a:spLocks noChangeShapeType="1"/>
            </p:cNvSpPr>
            <p:nvPr/>
          </p:nvSpPr>
          <p:spPr bwMode="auto">
            <a:xfrm>
              <a:off x="1423988" y="3854450"/>
              <a:ext cx="1588" cy="73025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92" name="Line 768"/>
            <p:cNvSpPr>
              <a:spLocks noChangeShapeType="1"/>
            </p:cNvSpPr>
            <p:nvPr/>
          </p:nvSpPr>
          <p:spPr bwMode="auto">
            <a:xfrm flipV="1">
              <a:off x="1423988" y="1308100"/>
              <a:ext cx="1588" cy="254635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93" name="Line 769"/>
            <p:cNvSpPr>
              <a:spLocks noChangeShapeType="1"/>
            </p:cNvSpPr>
            <p:nvPr/>
          </p:nvSpPr>
          <p:spPr bwMode="auto">
            <a:xfrm flipH="1">
              <a:off x="1350963" y="3854450"/>
              <a:ext cx="73025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94" name="Rectangle 770"/>
            <p:cNvSpPr>
              <a:spLocks noChangeArrowheads="1"/>
            </p:cNvSpPr>
            <p:nvPr/>
          </p:nvSpPr>
          <p:spPr bwMode="auto">
            <a:xfrm>
              <a:off x="1090613" y="3740150"/>
              <a:ext cx="21320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95" name="Line 771"/>
            <p:cNvSpPr>
              <a:spLocks noChangeShapeType="1"/>
            </p:cNvSpPr>
            <p:nvPr/>
          </p:nvSpPr>
          <p:spPr bwMode="auto">
            <a:xfrm flipH="1">
              <a:off x="1382713" y="3622675"/>
              <a:ext cx="41275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96" name="Line 772"/>
            <p:cNvSpPr>
              <a:spLocks noChangeShapeType="1"/>
            </p:cNvSpPr>
            <p:nvPr/>
          </p:nvSpPr>
          <p:spPr bwMode="auto">
            <a:xfrm flipH="1">
              <a:off x="1350963" y="3390900"/>
              <a:ext cx="73025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97" name="Rectangle 773"/>
            <p:cNvSpPr>
              <a:spLocks noChangeArrowheads="1"/>
            </p:cNvSpPr>
            <p:nvPr/>
          </p:nvSpPr>
          <p:spPr bwMode="auto">
            <a:xfrm>
              <a:off x="1090613" y="3276600"/>
              <a:ext cx="21320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98" name="Line 774"/>
            <p:cNvSpPr>
              <a:spLocks noChangeShapeType="1"/>
            </p:cNvSpPr>
            <p:nvPr/>
          </p:nvSpPr>
          <p:spPr bwMode="auto">
            <a:xfrm flipH="1">
              <a:off x="1382713" y="3160713"/>
              <a:ext cx="41275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99" name="Line 775"/>
            <p:cNvSpPr>
              <a:spLocks noChangeShapeType="1"/>
            </p:cNvSpPr>
            <p:nvPr/>
          </p:nvSpPr>
          <p:spPr bwMode="auto">
            <a:xfrm flipH="1">
              <a:off x="1350963" y="2928938"/>
              <a:ext cx="73025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800" name="Rectangle 776"/>
            <p:cNvSpPr>
              <a:spLocks noChangeArrowheads="1"/>
            </p:cNvSpPr>
            <p:nvPr/>
          </p:nvSpPr>
          <p:spPr bwMode="auto">
            <a:xfrm>
              <a:off x="1090613" y="2814638"/>
              <a:ext cx="21320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01" name="Line 777"/>
            <p:cNvSpPr>
              <a:spLocks noChangeShapeType="1"/>
            </p:cNvSpPr>
            <p:nvPr/>
          </p:nvSpPr>
          <p:spPr bwMode="auto">
            <a:xfrm flipH="1">
              <a:off x="1382713" y="2697163"/>
              <a:ext cx="41275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802" name="Line 778"/>
            <p:cNvSpPr>
              <a:spLocks noChangeShapeType="1"/>
            </p:cNvSpPr>
            <p:nvPr/>
          </p:nvSpPr>
          <p:spPr bwMode="auto">
            <a:xfrm flipH="1">
              <a:off x="1350963" y="2465388"/>
              <a:ext cx="73025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803" name="Rectangle 779"/>
            <p:cNvSpPr>
              <a:spLocks noChangeArrowheads="1"/>
            </p:cNvSpPr>
            <p:nvPr/>
          </p:nvSpPr>
          <p:spPr bwMode="auto">
            <a:xfrm>
              <a:off x="1090613" y="2351088"/>
              <a:ext cx="21320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6</a:t>
              </a:r>
              <a:endParaRPr kumimoji="0" 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04" name="Line 780"/>
            <p:cNvSpPr>
              <a:spLocks noChangeShapeType="1"/>
            </p:cNvSpPr>
            <p:nvPr/>
          </p:nvSpPr>
          <p:spPr bwMode="auto">
            <a:xfrm flipH="1">
              <a:off x="1382713" y="2235200"/>
              <a:ext cx="41275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805" name="Line 781"/>
            <p:cNvSpPr>
              <a:spLocks noChangeShapeType="1"/>
            </p:cNvSpPr>
            <p:nvPr/>
          </p:nvSpPr>
          <p:spPr bwMode="auto">
            <a:xfrm flipH="1">
              <a:off x="1350963" y="2005013"/>
              <a:ext cx="73025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806" name="Rectangle 782"/>
            <p:cNvSpPr>
              <a:spLocks noChangeArrowheads="1"/>
            </p:cNvSpPr>
            <p:nvPr/>
          </p:nvSpPr>
          <p:spPr bwMode="auto">
            <a:xfrm>
              <a:off x="1090613" y="1889125"/>
              <a:ext cx="21320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8</a:t>
              </a:r>
              <a:endParaRPr kumimoji="0" 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07" name="Line 783"/>
            <p:cNvSpPr>
              <a:spLocks noChangeShapeType="1"/>
            </p:cNvSpPr>
            <p:nvPr/>
          </p:nvSpPr>
          <p:spPr bwMode="auto">
            <a:xfrm flipH="1">
              <a:off x="1382713" y="1773238"/>
              <a:ext cx="41275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808" name="Line 784"/>
            <p:cNvSpPr>
              <a:spLocks noChangeShapeType="1"/>
            </p:cNvSpPr>
            <p:nvPr/>
          </p:nvSpPr>
          <p:spPr bwMode="auto">
            <a:xfrm flipH="1">
              <a:off x="1350963" y="1541463"/>
              <a:ext cx="73025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809" name="Rectangle 785"/>
            <p:cNvSpPr>
              <a:spLocks noChangeArrowheads="1"/>
            </p:cNvSpPr>
            <p:nvPr/>
          </p:nvSpPr>
          <p:spPr bwMode="auto">
            <a:xfrm>
              <a:off x="1090613" y="1427163"/>
              <a:ext cx="21320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10" name="Line 786"/>
            <p:cNvSpPr>
              <a:spLocks noChangeShapeType="1"/>
            </p:cNvSpPr>
            <p:nvPr/>
          </p:nvSpPr>
          <p:spPr bwMode="auto">
            <a:xfrm flipH="1">
              <a:off x="1382713" y="1309688"/>
              <a:ext cx="41275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817" name="Rectangle 793"/>
            <p:cNvSpPr>
              <a:spLocks noChangeArrowheads="1"/>
            </p:cNvSpPr>
            <p:nvPr/>
          </p:nvSpPr>
          <p:spPr bwMode="auto">
            <a:xfrm>
              <a:off x="2565400" y="4090988"/>
              <a:ext cx="488916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µM ara</a:t>
              </a:r>
              <a:endParaRPr kumimoji="0" 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57" name="Oval 733"/>
            <p:cNvSpPr>
              <a:spLocks noChangeArrowheads="1"/>
            </p:cNvSpPr>
            <p:nvPr/>
          </p:nvSpPr>
          <p:spPr bwMode="auto">
            <a:xfrm>
              <a:off x="1644650" y="1420813"/>
              <a:ext cx="104775" cy="103188"/>
            </a:xfrm>
            <a:prstGeom prst="ellipse">
              <a:avLst/>
            </a:prstGeom>
            <a:solidFill>
              <a:schemeClr val="bg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58" name="Oval 734"/>
            <p:cNvSpPr>
              <a:spLocks noChangeArrowheads="1"/>
            </p:cNvSpPr>
            <p:nvPr/>
          </p:nvSpPr>
          <p:spPr bwMode="auto">
            <a:xfrm>
              <a:off x="1935163" y="1257300"/>
              <a:ext cx="103188" cy="103188"/>
            </a:xfrm>
            <a:prstGeom prst="ellipse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59" name="Oval 735"/>
            <p:cNvSpPr>
              <a:spLocks noChangeArrowheads="1"/>
            </p:cNvSpPr>
            <p:nvPr/>
          </p:nvSpPr>
          <p:spPr bwMode="auto">
            <a:xfrm>
              <a:off x="2201863" y="1466850"/>
              <a:ext cx="104775" cy="104775"/>
            </a:xfrm>
            <a:prstGeom prst="ellipse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60" name="Oval 736"/>
            <p:cNvSpPr>
              <a:spLocks noChangeArrowheads="1"/>
            </p:cNvSpPr>
            <p:nvPr/>
          </p:nvSpPr>
          <p:spPr bwMode="auto">
            <a:xfrm>
              <a:off x="2493963" y="2230438"/>
              <a:ext cx="103188" cy="104775"/>
            </a:xfrm>
            <a:prstGeom prst="ellipse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61" name="Oval 737"/>
            <p:cNvSpPr>
              <a:spLocks noChangeArrowheads="1"/>
            </p:cNvSpPr>
            <p:nvPr/>
          </p:nvSpPr>
          <p:spPr bwMode="auto">
            <a:xfrm>
              <a:off x="2760663" y="3040063"/>
              <a:ext cx="103188" cy="103188"/>
            </a:xfrm>
            <a:prstGeom prst="ellipse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62" name="Oval 738"/>
            <p:cNvSpPr>
              <a:spLocks noChangeArrowheads="1"/>
            </p:cNvSpPr>
            <p:nvPr/>
          </p:nvSpPr>
          <p:spPr bwMode="auto">
            <a:xfrm>
              <a:off x="3051175" y="3503613"/>
              <a:ext cx="104775" cy="104775"/>
            </a:xfrm>
            <a:prstGeom prst="ellipse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63" name="Oval 739"/>
            <p:cNvSpPr>
              <a:spLocks noChangeArrowheads="1"/>
            </p:cNvSpPr>
            <p:nvPr/>
          </p:nvSpPr>
          <p:spPr bwMode="auto">
            <a:xfrm>
              <a:off x="1384909" y="1484965"/>
              <a:ext cx="104775" cy="104775"/>
            </a:xfrm>
            <a:prstGeom prst="ellipse">
              <a:avLst/>
            </a:prstGeom>
            <a:solidFill>
              <a:srgbClr val="00FF00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64" name="Oval 740"/>
            <p:cNvSpPr>
              <a:spLocks noChangeArrowheads="1"/>
            </p:cNvSpPr>
            <p:nvPr/>
          </p:nvSpPr>
          <p:spPr bwMode="auto">
            <a:xfrm>
              <a:off x="1644650" y="1490663"/>
              <a:ext cx="104775" cy="104775"/>
            </a:xfrm>
            <a:prstGeom prst="ellipse">
              <a:avLst/>
            </a:prstGeom>
            <a:solidFill>
              <a:srgbClr val="00FF00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65" name="Oval 741"/>
            <p:cNvSpPr>
              <a:spLocks noChangeArrowheads="1"/>
            </p:cNvSpPr>
            <p:nvPr/>
          </p:nvSpPr>
          <p:spPr bwMode="auto">
            <a:xfrm>
              <a:off x="1935163" y="1373188"/>
              <a:ext cx="103188" cy="104775"/>
            </a:xfrm>
            <a:prstGeom prst="ellipse">
              <a:avLst/>
            </a:prstGeom>
            <a:solidFill>
              <a:srgbClr val="00FF00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66" name="Oval 742"/>
            <p:cNvSpPr>
              <a:spLocks noChangeArrowheads="1"/>
            </p:cNvSpPr>
            <p:nvPr/>
          </p:nvSpPr>
          <p:spPr bwMode="auto">
            <a:xfrm>
              <a:off x="2201863" y="1674813"/>
              <a:ext cx="104775" cy="104775"/>
            </a:xfrm>
            <a:prstGeom prst="ellipse">
              <a:avLst/>
            </a:prstGeom>
            <a:solidFill>
              <a:srgbClr val="00FF00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67" name="Oval 743"/>
            <p:cNvSpPr>
              <a:spLocks noChangeArrowheads="1"/>
            </p:cNvSpPr>
            <p:nvPr/>
          </p:nvSpPr>
          <p:spPr bwMode="auto">
            <a:xfrm>
              <a:off x="2493963" y="2530475"/>
              <a:ext cx="103188" cy="103188"/>
            </a:xfrm>
            <a:prstGeom prst="ellipse">
              <a:avLst/>
            </a:prstGeom>
            <a:solidFill>
              <a:srgbClr val="00FF00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68" name="Oval 744"/>
            <p:cNvSpPr>
              <a:spLocks noChangeArrowheads="1"/>
            </p:cNvSpPr>
            <p:nvPr/>
          </p:nvSpPr>
          <p:spPr bwMode="auto">
            <a:xfrm>
              <a:off x="2760663" y="3109913"/>
              <a:ext cx="103188" cy="103188"/>
            </a:xfrm>
            <a:prstGeom prst="ellipse">
              <a:avLst/>
            </a:prstGeom>
            <a:solidFill>
              <a:srgbClr val="00FF00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69" name="Oval 745"/>
            <p:cNvSpPr>
              <a:spLocks noChangeArrowheads="1"/>
            </p:cNvSpPr>
            <p:nvPr/>
          </p:nvSpPr>
          <p:spPr bwMode="auto">
            <a:xfrm>
              <a:off x="3051175" y="3481388"/>
              <a:ext cx="104775" cy="103188"/>
            </a:xfrm>
            <a:prstGeom prst="ellipse">
              <a:avLst/>
            </a:prstGeom>
            <a:solidFill>
              <a:srgbClr val="00FF00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70" name="Oval 746"/>
            <p:cNvSpPr>
              <a:spLocks noChangeArrowheads="1"/>
            </p:cNvSpPr>
            <p:nvPr/>
          </p:nvSpPr>
          <p:spPr bwMode="auto">
            <a:xfrm>
              <a:off x="1350725" y="1484965"/>
              <a:ext cx="104775" cy="104775"/>
            </a:xfrm>
            <a:prstGeom prst="ellipse">
              <a:avLst/>
            </a:prstGeom>
            <a:solidFill>
              <a:schemeClr val="bg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71" name="Oval 747"/>
            <p:cNvSpPr>
              <a:spLocks noChangeArrowheads="1"/>
            </p:cNvSpPr>
            <p:nvPr/>
          </p:nvSpPr>
          <p:spPr bwMode="auto">
            <a:xfrm>
              <a:off x="1811338" y="1768475"/>
              <a:ext cx="104775" cy="104775"/>
            </a:xfrm>
            <a:prstGeom prst="ellipse">
              <a:avLst/>
            </a:prstGeom>
            <a:solidFill>
              <a:schemeClr val="bg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72" name="Oval 748"/>
            <p:cNvSpPr>
              <a:spLocks noChangeArrowheads="1"/>
            </p:cNvSpPr>
            <p:nvPr/>
          </p:nvSpPr>
          <p:spPr bwMode="auto">
            <a:xfrm>
              <a:off x="2370138" y="2298700"/>
              <a:ext cx="104775" cy="104775"/>
            </a:xfrm>
            <a:prstGeom prst="ellipse">
              <a:avLst/>
            </a:prstGeom>
            <a:solidFill>
              <a:schemeClr val="bg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73" name="Oval 749"/>
            <p:cNvSpPr>
              <a:spLocks noChangeArrowheads="1"/>
            </p:cNvSpPr>
            <p:nvPr/>
          </p:nvSpPr>
          <p:spPr bwMode="auto">
            <a:xfrm>
              <a:off x="2928938" y="3759200"/>
              <a:ext cx="103188" cy="103188"/>
            </a:xfrm>
            <a:prstGeom prst="ellipse">
              <a:avLst/>
            </a:prstGeom>
            <a:solidFill>
              <a:schemeClr val="bg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74" name="Oval 750"/>
            <p:cNvSpPr>
              <a:spLocks noChangeArrowheads="1"/>
            </p:cNvSpPr>
            <p:nvPr/>
          </p:nvSpPr>
          <p:spPr bwMode="auto">
            <a:xfrm>
              <a:off x="3486150" y="3802063"/>
              <a:ext cx="104775" cy="104775"/>
            </a:xfrm>
            <a:prstGeom prst="ellipse">
              <a:avLst/>
            </a:prstGeom>
            <a:solidFill>
              <a:schemeClr val="bg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775" name="Oval 751"/>
            <p:cNvSpPr>
              <a:spLocks noChangeArrowheads="1"/>
            </p:cNvSpPr>
            <p:nvPr/>
          </p:nvSpPr>
          <p:spPr bwMode="auto">
            <a:xfrm>
              <a:off x="4044950" y="3802063"/>
              <a:ext cx="103188" cy="104775"/>
            </a:xfrm>
            <a:prstGeom prst="ellipse">
              <a:avLst/>
            </a:prstGeom>
            <a:solidFill>
              <a:schemeClr val="bg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NZ"/>
            </a:p>
          </p:txBody>
        </p:sp>
        <p:sp>
          <p:nvSpPr>
            <p:cNvPr id="1005" name="Rectangle 54"/>
            <p:cNvSpPr>
              <a:spLocks noChangeArrowheads="1"/>
            </p:cNvSpPr>
            <p:nvPr/>
          </p:nvSpPr>
          <p:spPr bwMode="auto">
            <a:xfrm rot="16200000">
              <a:off x="104621" y="2544736"/>
              <a:ext cx="1636712" cy="2079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. act. fr. unsilenced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016" name="TextBox 1015"/>
          <p:cNvSpPr txBox="1"/>
          <p:nvPr/>
        </p:nvSpPr>
        <p:spPr>
          <a:xfrm>
            <a:off x="841462" y="104405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smtClean="0">
                <a:latin typeface="Arial" pitchFamily="34" charset="0"/>
                <a:cs typeface="Arial" pitchFamily="34" charset="0"/>
              </a:rPr>
              <a:t>A</a:t>
            </a:r>
            <a:endParaRPr lang="en-NZ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017" name="Rectangle 1016"/>
          <p:cNvSpPr/>
          <p:nvPr/>
        </p:nvSpPr>
        <p:spPr>
          <a:xfrm>
            <a:off x="4535701" y="1044059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smtClean="0">
                <a:latin typeface="Arial" pitchFamily="34" charset="0"/>
                <a:cs typeface="Arial" pitchFamily="34" charset="0"/>
              </a:rPr>
              <a:t> B</a:t>
            </a:r>
            <a:endParaRPr lang="en-NZ"/>
          </a:p>
        </p:txBody>
      </p:sp>
      <p:sp>
        <p:nvSpPr>
          <p:cNvPr id="1018" name="Rectangle 1017"/>
          <p:cNvSpPr/>
          <p:nvPr/>
        </p:nvSpPr>
        <p:spPr>
          <a:xfrm>
            <a:off x="4535701" y="3406259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smtClean="0">
                <a:latin typeface="Arial" pitchFamily="34" charset="0"/>
                <a:cs typeface="Arial" pitchFamily="34" charset="0"/>
              </a:rPr>
              <a:t> C</a:t>
            </a:r>
            <a:endParaRPr lang="en-NZ"/>
          </a:p>
        </p:txBody>
      </p:sp>
      <p:sp>
        <p:nvSpPr>
          <p:cNvPr id="1019" name="TextBox 1018"/>
          <p:cNvSpPr txBox="1"/>
          <p:nvPr/>
        </p:nvSpPr>
        <p:spPr>
          <a:xfrm>
            <a:off x="1441537" y="5349359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Arial" pitchFamily="34" charset="0"/>
                <a:cs typeface="Arial" pitchFamily="34" charset="0"/>
              </a:rPr>
              <a:t>Fig. </a:t>
            </a:r>
            <a:r>
              <a:rPr lang="en-GB" b="1" dirty="0" smtClean="0">
                <a:latin typeface="Arial" pitchFamily="34" charset="0"/>
                <a:cs typeface="Arial" pitchFamily="34" charset="0"/>
              </a:rPr>
              <a:t>S4</a:t>
            </a:r>
            <a:endParaRPr lang="en-NZ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8</TotalTime>
  <Words>80</Words>
  <Application>Microsoft Office PowerPoint</Application>
  <PresentationFormat>On-screen Show (4:3)</PresentationFormat>
  <Paragraphs>5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ave</dc:creator>
  <cp:lastModifiedBy>Dave</cp:lastModifiedBy>
  <cp:revision>9</cp:revision>
  <dcterms:created xsi:type="dcterms:W3CDTF">2019-08-11T12:03:00Z</dcterms:created>
  <dcterms:modified xsi:type="dcterms:W3CDTF">2020-02-26T09:59:58Z</dcterms:modified>
</cp:coreProperties>
</file>